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3D3EB4E-0FDD-DAB9-62B5-5D4BB27E12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2682DAF0-A4E4-7F40-CA35-1F428FAD0B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127DD6F-8282-D826-742E-4BDF75900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CE589A8-07C2-D398-5024-84D814B25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03BBE8ED-4132-90C9-D9C1-A14AA0D62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0677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A18142C-CDFE-547F-3C69-4B12251288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6A171963-386D-8D95-5487-EF002306F2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178EA5D-CEED-8F7A-434F-A3B8B72A2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EF3970C-B95F-CE71-BD56-79AE731F5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7AFB0A5-2092-22E5-329D-3CC07FC06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1834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8F90296C-F140-C5D5-3839-44D222BF9F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A9F68C5D-AF0B-00A6-2382-21BEFD512F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B613BAB-988B-B11B-2CAA-44C53106C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4D4BD31-E7B0-2CB8-DBD0-E113E8526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A9BDE5A-DA49-2D4F-AE08-0FDC2C3DD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9603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306890D-953B-A523-D491-7F11DB806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2838409-7F06-49AF-1375-9FAF69F3AC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7BA1735-F4C4-E5BC-C631-087F053E5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D762BD8-419F-7B68-FE0A-D96246A61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2EA530B-D3BB-C24F-1E63-A92F4F983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71500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CFA2DBD-226E-9F87-01DC-4E0CBE759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3923EEC-2545-A34E-C388-145E73517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6D1716F-41BC-3A0A-79C9-9FD600D76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4E20AF0-E01B-DCF0-E353-F7FF3A543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524D8FD-7037-A81D-67CF-CB81A477C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03048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911CB4C-2B15-3509-45F7-2DF644714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F3411103-0948-6130-A09E-941C0219A8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18316E82-BE57-3BF8-74A7-11D4B0C1A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DA4B0C3F-BF58-D699-510B-7C314233E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6EF3B0B-C6D5-5572-39AF-7E87BF07C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24B19B3-1C44-EE5A-2E54-7BE1FD226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49160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6051A81-9269-A031-1439-951A50176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E735BDB-B78C-6A5D-387C-9E948F2F36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039BE8D8-D06E-CA01-0348-C8A09ED7AD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907B9B77-D522-8C56-EB62-7826ACC5A5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112960BD-3823-CB1D-8794-322A75235C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10AE7140-FBD9-81AC-591D-8DDEBCCF8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520E7E60-A060-B8DC-9C33-E70F3D996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75F0E0F3-9A79-AED0-14F1-3B2DCF3C3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3711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CA2F278-0655-A398-F982-468D2E6EBA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6146CBDF-52F2-03AB-FEB4-37DCD6317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7CD74A26-663F-59A7-4AFD-2EE2CFC87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C9E09467-A6FE-5B16-165E-67E685704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96912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5D9A19CE-B9A8-05B5-79B8-68D7A645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C39B68FF-469A-0288-2C31-DE640D68D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454C1566-9FFE-391A-B50C-EDCCA4148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58426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C8E1726-18C6-98BC-3C9B-42E98B9F0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6B4EF117-5E4C-53D6-C6FD-2B8503E285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76CE4C73-1399-26BF-5064-BF2FE49638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24034B12-3B4D-3E0E-1850-125039B32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80C3718-0B99-1E4D-A5BE-4F02CF65C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056087C-2178-34D1-9999-525FD44C0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91772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241D0E5-3CC6-BB73-7801-1E21358692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A4550096-2B35-7649-C9A6-92525879B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DF7DFFC-5EDD-592F-907A-AEBD2A0CD7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A50EBCD-5314-6286-2A6A-F239C7064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EFBC52E-3B91-39DA-1EF3-A7A88562A8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C8AA4DE-44D0-E589-9C32-F95830450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0532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6CE8559C-B575-BF2E-B70B-D19E0B524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DEA01872-7F80-2350-ED99-961E6B4DE1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8E67A6B-F86B-E496-F259-CC5BD46D6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C9C150-77B5-4C87-B17F-3F93BA6E7554}" type="datetimeFigureOut">
              <a:rPr lang="hu-HU" smtClean="0"/>
              <a:t>2024. 11. 21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A164B19-A872-2E22-BE5E-9D6EAA68BA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7DFAC13-AB3A-0719-EBE6-7F346631DA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F0FF88-5C60-4CD4-A54D-1BC5532EAA2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42160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"/><Relationship Id="rId13" Type="http://schemas.openxmlformats.org/officeDocument/2006/relationships/image" Target="../media/image22.tif"/><Relationship Id="rId3" Type="http://schemas.openxmlformats.org/officeDocument/2006/relationships/image" Target="../media/image12.tif"/><Relationship Id="rId7" Type="http://schemas.openxmlformats.org/officeDocument/2006/relationships/image" Target="../media/image16.tif"/><Relationship Id="rId12" Type="http://schemas.openxmlformats.org/officeDocument/2006/relationships/image" Target="../media/image21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tif"/><Relationship Id="rId11" Type="http://schemas.openxmlformats.org/officeDocument/2006/relationships/image" Target="../media/image20.tif"/><Relationship Id="rId5" Type="http://schemas.openxmlformats.org/officeDocument/2006/relationships/image" Target="../media/image14.tif"/><Relationship Id="rId10" Type="http://schemas.openxmlformats.org/officeDocument/2006/relationships/image" Target="../media/image19.tif"/><Relationship Id="rId4" Type="http://schemas.openxmlformats.org/officeDocument/2006/relationships/image" Target="../media/image13.tif"/><Relationship Id="rId9" Type="http://schemas.openxmlformats.org/officeDocument/2006/relationships/image" Target="../media/image1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38A938F5-A163-0F79-8D2C-EFFD68AF06FE}"/>
              </a:ext>
            </a:extLst>
          </p:cNvPr>
          <p:cNvSpPr txBox="1"/>
          <p:nvPr/>
        </p:nvSpPr>
        <p:spPr>
          <a:xfrm>
            <a:off x="68367" y="68366"/>
            <a:ext cx="2644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EMT </a:t>
            </a:r>
            <a:r>
              <a:rPr lang="hu-HU" b="1" dirty="0" err="1"/>
              <a:t>markers</a:t>
            </a:r>
            <a:r>
              <a:rPr lang="hu-HU" b="1" dirty="0"/>
              <a:t>:</a:t>
            </a:r>
          </a:p>
        </p:txBody>
      </p:sp>
      <p:grpSp>
        <p:nvGrpSpPr>
          <p:cNvPr id="140" name="Csoportba foglalás 139">
            <a:extLst>
              <a:ext uri="{FF2B5EF4-FFF2-40B4-BE49-F238E27FC236}">
                <a16:creationId xmlns:a16="http://schemas.microsoft.com/office/drawing/2014/main" id="{D3AA2FA8-B563-C562-D3DD-A3C6CEA723A0}"/>
              </a:ext>
            </a:extLst>
          </p:cNvPr>
          <p:cNvGrpSpPr/>
          <p:nvPr/>
        </p:nvGrpSpPr>
        <p:grpSpPr>
          <a:xfrm>
            <a:off x="68367" y="378270"/>
            <a:ext cx="11964550" cy="2059144"/>
            <a:chOff x="68367" y="378270"/>
            <a:chExt cx="11964550" cy="2059144"/>
          </a:xfrm>
        </p:grpSpPr>
        <p:sp>
          <p:nvSpPr>
            <p:cNvPr id="126" name="Szövegdoboz 125">
              <a:extLst>
                <a:ext uri="{FF2B5EF4-FFF2-40B4-BE49-F238E27FC236}">
                  <a16:creationId xmlns:a16="http://schemas.microsoft.com/office/drawing/2014/main" id="{4CA71D5A-0EF2-0FE5-8F76-25D7BE5288B9}"/>
                </a:ext>
              </a:extLst>
            </p:cNvPr>
            <p:cNvSpPr txBox="1"/>
            <p:nvPr/>
          </p:nvSpPr>
          <p:spPr>
            <a:xfrm>
              <a:off x="5636506" y="1518705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DMSO</a:t>
              </a:r>
            </a:p>
          </p:txBody>
        </p:sp>
        <p:sp>
          <p:nvSpPr>
            <p:cNvPr id="129" name="Szövegdoboz 128">
              <a:extLst>
                <a:ext uri="{FF2B5EF4-FFF2-40B4-BE49-F238E27FC236}">
                  <a16:creationId xmlns:a16="http://schemas.microsoft.com/office/drawing/2014/main" id="{7FA96450-2F48-D242-5921-9398FF9E4EBB}"/>
                </a:ext>
              </a:extLst>
            </p:cNvPr>
            <p:cNvSpPr txBox="1"/>
            <p:nvPr/>
          </p:nvSpPr>
          <p:spPr>
            <a:xfrm>
              <a:off x="6828088" y="1525040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UDCA</a:t>
              </a:r>
            </a:p>
          </p:txBody>
        </p:sp>
        <p:sp>
          <p:nvSpPr>
            <p:cNvPr id="130" name="Szövegdoboz 129">
              <a:extLst>
                <a:ext uri="{FF2B5EF4-FFF2-40B4-BE49-F238E27FC236}">
                  <a16:creationId xmlns:a16="http://schemas.microsoft.com/office/drawing/2014/main" id="{AE7E2569-03F4-7245-DCD8-469F86CB12C5}"/>
                </a:ext>
              </a:extLst>
            </p:cNvPr>
            <p:cNvSpPr txBox="1"/>
            <p:nvPr/>
          </p:nvSpPr>
          <p:spPr>
            <a:xfrm>
              <a:off x="2010460" y="1516044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DMSO</a:t>
              </a:r>
            </a:p>
          </p:txBody>
        </p:sp>
        <p:sp>
          <p:nvSpPr>
            <p:cNvPr id="131" name="Szövegdoboz 130">
              <a:extLst>
                <a:ext uri="{FF2B5EF4-FFF2-40B4-BE49-F238E27FC236}">
                  <a16:creationId xmlns:a16="http://schemas.microsoft.com/office/drawing/2014/main" id="{FCA8F831-EE7B-D45F-BA6E-0C4DD008A231}"/>
                </a:ext>
              </a:extLst>
            </p:cNvPr>
            <p:cNvSpPr txBox="1"/>
            <p:nvPr/>
          </p:nvSpPr>
          <p:spPr>
            <a:xfrm>
              <a:off x="3503705" y="1522379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UDCA</a:t>
              </a:r>
            </a:p>
          </p:txBody>
        </p:sp>
        <p:sp>
          <p:nvSpPr>
            <p:cNvPr id="132" name="Szövegdoboz 131">
              <a:extLst>
                <a:ext uri="{FF2B5EF4-FFF2-40B4-BE49-F238E27FC236}">
                  <a16:creationId xmlns:a16="http://schemas.microsoft.com/office/drawing/2014/main" id="{9F186B5B-FDD0-E53C-E82E-D73646B647CB}"/>
                </a:ext>
              </a:extLst>
            </p:cNvPr>
            <p:cNvSpPr txBox="1"/>
            <p:nvPr/>
          </p:nvSpPr>
          <p:spPr>
            <a:xfrm>
              <a:off x="9606694" y="1510630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DMSO</a:t>
              </a:r>
            </a:p>
          </p:txBody>
        </p:sp>
        <p:sp>
          <p:nvSpPr>
            <p:cNvPr id="133" name="Szövegdoboz 132">
              <a:extLst>
                <a:ext uri="{FF2B5EF4-FFF2-40B4-BE49-F238E27FC236}">
                  <a16:creationId xmlns:a16="http://schemas.microsoft.com/office/drawing/2014/main" id="{D7D4D9D7-171A-3D8A-DA47-60BCD6F09B6C}"/>
                </a:ext>
              </a:extLst>
            </p:cNvPr>
            <p:cNvSpPr txBox="1"/>
            <p:nvPr/>
          </p:nvSpPr>
          <p:spPr>
            <a:xfrm>
              <a:off x="10382630" y="1514943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UDCA</a:t>
              </a:r>
            </a:p>
          </p:txBody>
        </p:sp>
        <p:grpSp>
          <p:nvGrpSpPr>
            <p:cNvPr id="139" name="Csoportba foglalás 138">
              <a:extLst>
                <a:ext uri="{FF2B5EF4-FFF2-40B4-BE49-F238E27FC236}">
                  <a16:creationId xmlns:a16="http://schemas.microsoft.com/office/drawing/2014/main" id="{612D3754-54EE-EBF9-A04B-4F7ADE86CCDC}"/>
                </a:ext>
              </a:extLst>
            </p:cNvPr>
            <p:cNvGrpSpPr/>
            <p:nvPr/>
          </p:nvGrpSpPr>
          <p:grpSpPr>
            <a:xfrm>
              <a:off x="68367" y="378270"/>
              <a:ext cx="11964550" cy="2059144"/>
              <a:chOff x="68367" y="378270"/>
              <a:chExt cx="11964550" cy="2059144"/>
            </a:xfrm>
          </p:grpSpPr>
          <p:grpSp>
            <p:nvGrpSpPr>
              <p:cNvPr id="123" name="Csoportba foglalás 122">
                <a:extLst>
                  <a:ext uri="{FF2B5EF4-FFF2-40B4-BE49-F238E27FC236}">
                    <a16:creationId xmlns:a16="http://schemas.microsoft.com/office/drawing/2014/main" id="{5D3C71F7-83B8-F029-1050-A2BBF89D63A8}"/>
                  </a:ext>
                </a:extLst>
              </p:cNvPr>
              <p:cNvGrpSpPr/>
              <p:nvPr/>
            </p:nvGrpSpPr>
            <p:grpSpPr>
              <a:xfrm>
                <a:off x="68367" y="378270"/>
                <a:ext cx="11964550" cy="2059144"/>
                <a:chOff x="68367" y="378270"/>
                <a:chExt cx="11964550" cy="2059144"/>
              </a:xfrm>
            </p:grpSpPr>
            <p:grpSp>
              <p:nvGrpSpPr>
                <p:cNvPr id="86" name="Csoportba foglalás 85">
                  <a:extLst>
                    <a:ext uri="{FF2B5EF4-FFF2-40B4-BE49-F238E27FC236}">
                      <a16:creationId xmlns:a16="http://schemas.microsoft.com/office/drawing/2014/main" id="{7D3FA025-DEEB-62F2-67D2-249BFF435760}"/>
                    </a:ext>
                  </a:extLst>
                </p:cNvPr>
                <p:cNvGrpSpPr/>
                <p:nvPr/>
              </p:nvGrpSpPr>
              <p:grpSpPr>
                <a:xfrm>
                  <a:off x="68367" y="378270"/>
                  <a:ext cx="11964550" cy="2059144"/>
                  <a:chOff x="68367" y="378270"/>
                  <a:chExt cx="11964550" cy="2059144"/>
                </a:xfrm>
              </p:grpSpPr>
              <p:sp>
                <p:nvSpPr>
                  <p:cNvPr id="71" name="Szövegdoboz 70">
                    <a:extLst>
                      <a:ext uri="{FF2B5EF4-FFF2-40B4-BE49-F238E27FC236}">
                        <a16:creationId xmlns:a16="http://schemas.microsoft.com/office/drawing/2014/main" id="{BFEF4909-65F1-3BFB-90C8-40DE559324DE}"/>
                      </a:ext>
                    </a:extLst>
                  </p:cNvPr>
                  <p:cNvSpPr txBox="1"/>
                  <p:nvPr/>
                </p:nvSpPr>
                <p:spPr>
                  <a:xfrm>
                    <a:off x="5644365" y="640438"/>
                    <a:ext cx="4700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DMSO</a:t>
                    </a:r>
                  </a:p>
                </p:txBody>
              </p:sp>
              <p:sp>
                <p:nvSpPr>
                  <p:cNvPr id="73" name="Szövegdoboz 72">
                    <a:extLst>
                      <a:ext uri="{FF2B5EF4-FFF2-40B4-BE49-F238E27FC236}">
                        <a16:creationId xmlns:a16="http://schemas.microsoft.com/office/drawing/2014/main" id="{054074E7-6D06-8123-FE86-1D87BBE2CF4A}"/>
                      </a:ext>
                    </a:extLst>
                  </p:cNvPr>
                  <p:cNvSpPr txBox="1"/>
                  <p:nvPr/>
                </p:nvSpPr>
                <p:spPr>
                  <a:xfrm>
                    <a:off x="6835947" y="646773"/>
                    <a:ext cx="45717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UDCA</a:t>
                    </a:r>
                  </a:p>
                </p:txBody>
              </p:sp>
              <p:grpSp>
                <p:nvGrpSpPr>
                  <p:cNvPr id="85" name="Csoportba foglalás 84">
                    <a:extLst>
                      <a:ext uri="{FF2B5EF4-FFF2-40B4-BE49-F238E27FC236}">
                        <a16:creationId xmlns:a16="http://schemas.microsoft.com/office/drawing/2014/main" id="{B4B0054F-3B54-F916-C6A2-0DF28595FCD4}"/>
                      </a:ext>
                    </a:extLst>
                  </p:cNvPr>
                  <p:cNvGrpSpPr/>
                  <p:nvPr/>
                </p:nvGrpSpPr>
                <p:grpSpPr>
                  <a:xfrm>
                    <a:off x="68367" y="378270"/>
                    <a:ext cx="11964550" cy="2059144"/>
                    <a:chOff x="68367" y="378270"/>
                    <a:chExt cx="11964550" cy="2059144"/>
                  </a:xfrm>
                </p:grpSpPr>
                <p:grpSp>
                  <p:nvGrpSpPr>
                    <p:cNvPr id="59" name="Csoportba foglalás 58">
                      <a:extLst>
                        <a:ext uri="{FF2B5EF4-FFF2-40B4-BE49-F238E27FC236}">
                          <a16:creationId xmlns:a16="http://schemas.microsoft.com/office/drawing/2014/main" id="{BCFC102F-8238-9EFE-B3C3-FC37A2964B9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367" y="378270"/>
                      <a:ext cx="11964550" cy="2059144"/>
                      <a:chOff x="68367" y="378270"/>
                      <a:chExt cx="11964550" cy="2059144"/>
                    </a:xfrm>
                  </p:grpSpPr>
                  <p:grpSp>
                    <p:nvGrpSpPr>
                      <p:cNvPr id="32" name="Csoportba foglalás 31">
                        <a:extLst>
                          <a:ext uri="{FF2B5EF4-FFF2-40B4-BE49-F238E27FC236}">
                            <a16:creationId xmlns:a16="http://schemas.microsoft.com/office/drawing/2014/main" id="{A4E1A865-A5BC-6955-D1D6-35B050A6E3E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8367" y="378270"/>
                        <a:ext cx="11964550" cy="2059144"/>
                        <a:chOff x="68367" y="378270"/>
                        <a:chExt cx="11964550" cy="2059144"/>
                      </a:xfrm>
                    </p:grpSpPr>
                    <p:grpSp>
                      <p:nvGrpSpPr>
                        <p:cNvPr id="15" name="Csoportba foglalás 14">
                          <a:extLst>
                            <a:ext uri="{FF2B5EF4-FFF2-40B4-BE49-F238E27FC236}">
                              <a16:creationId xmlns:a16="http://schemas.microsoft.com/office/drawing/2014/main" id="{E6AAAECA-B34F-8D7F-FB1B-CD05B6B0660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8367" y="378270"/>
                          <a:ext cx="11964550" cy="2059144"/>
                          <a:chOff x="68367" y="378270"/>
                          <a:chExt cx="11964550" cy="2059144"/>
                        </a:xfrm>
                      </p:grpSpPr>
                      <p:grpSp>
                        <p:nvGrpSpPr>
                          <p:cNvPr id="42" name="Csoportba foglalás 41">
                            <a:extLst>
                              <a:ext uri="{FF2B5EF4-FFF2-40B4-BE49-F238E27FC236}">
                                <a16:creationId xmlns:a16="http://schemas.microsoft.com/office/drawing/2014/main" id="{C1BC4136-039D-2823-C992-EE7799EEE208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8367" y="378270"/>
                            <a:ext cx="11964550" cy="2059144"/>
                            <a:chOff x="68367" y="415477"/>
                            <a:chExt cx="11964550" cy="2059144"/>
                          </a:xfrm>
                        </p:grpSpPr>
                        <p:sp>
                          <p:nvSpPr>
                            <p:cNvPr id="5" name="Szövegdoboz 4">
                              <a:extLst>
                                <a:ext uri="{FF2B5EF4-FFF2-40B4-BE49-F238E27FC236}">
                                  <a16:creationId xmlns:a16="http://schemas.microsoft.com/office/drawing/2014/main" id="{2D15ECA6-3D15-AB1E-0C0A-45893045C96B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68367" y="1048238"/>
                              <a:ext cx="1375711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hu-HU" sz="1400" dirty="0"/>
                                <a:t>β-</a:t>
                              </a:r>
                              <a:r>
                                <a:rPr lang="hu-HU" sz="1400" dirty="0" err="1"/>
                                <a:t>catenin</a:t>
                              </a:r>
                              <a:r>
                                <a:rPr lang="hu-HU" sz="1400" dirty="0"/>
                                <a:t>:</a:t>
                              </a:r>
                            </a:p>
                          </p:txBody>
                        </p:sp>
                        <p:sp>
                          <p:nvSpPr>
                            <p:cNvPr id="14" name="Szövegdoboz 13">
                              <a:extLst>
                                <a:ext uri="{FF2B5EF4-FFF2-40B4-BE49-F238E27FC236}">
                                  <a16:creationId xmlns:a16="http://schemas.microsoft.com/office/drawing/2014/main" id="{55B17E81-B9EA-2BCA-5E17-6EF9A23A7493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68367" y="1815547"/>
                              <a:ext cx="1067462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hu-HU" sz="1400" dirty="0"/>
                                <a:t>β-</a:t>
                              </a:r>
                              <a:r>
                                <a:rPr lang="hu-HU" sz="1400" dirty="0" err="1"/>
                                <a:t>actin</a:t>
                              </a:r>
                              <a:r>
                                <a:rPr lang="hu-HU" sz="1400" dirty="0"/>
                                <a:t>:</a:t>
                              </a:r>
                            </a:p>
                          </p:txBody>
                        </p:sp>
                        <p:grpSp>
                          <p:nvGrpSpPr>
                            <p:cNvPr id="29" name="Csoportba foglalás 28">
                              <a:extLst>
                                <a:ext uri="{FF2B5EF4-FFF2-40B4-BE49-F238E27FC236}">
                                  <a16:creationId xmlns:a16="http://schemas.microsoft.com/office/drawing/2014/main" id="{C7862503-4064-198C-6A1D-00D53F6D6917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2018319" y="415641"/>
                              <a:ext cx="1950421" cy="481122"/>
                              <a:chOff x="2018319" y="415641"/>
                              <a:chExt cx="1950421" cy="481122"/>
                            </a:xfrm>
                          </p:grpSpPr>
                          <p:grpSp>
                            <p:nvGrpSpPr>
                              <p:cNvPr id="11" name="Csoportba foglalás 10">
                                <a:extLst>
                                  <a:ext uri="{FF2B5EF4-FFF2-40B4-BE49-F238E27FC236}">
                                    <a16:creationId xmlns:a16="http://schemas.microsoft.com/office/drawing/2014/main" id="{BE2B1027-9424-DC70-35E4-7FFDB6CD836A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2018319" y="674984"/>
                                <a:ext cx="1950421" cy="221779"/>
                                <a:chOff x="2018319" y="298974"/>
                                <a:chExt cx="1950421" cy="221779"/>
                              </a:xfrm>
                            </p:grpSpPr>
                            <p:sp>
                              <p:nvSpPr>
                                <p:cNvPr id="9" name="Szövegdoboz 8">
                                  <a:extLst>
                                    <a:ext uri="{FF2B5EF4-FFF2-40B4-BE49-F238E27FC236}">
                                      <a16:creationId xmlns:a16="http://schemas.microsoft.com/office/drawing/2014/main" id="{7EA38758-1AE7-5276-DF13-D9B8F3E3A32C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2018319" y="298974"/>
                                  <a:ext cx="47000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DMSO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0" name="Szövegdoboz 9">
                                  <a:extLst>
                                    <a:ext uri="{FF2B5EF4-FFF2-40B4-BE49-F238E27FC236}">
                                      <a16:creationId xmlns:a16="http://schemas.microsoft.com/office/drawing/2014/main" id="{E3FCEE87-856D-1F43-3A31-90074D4DC8BB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3511564" y="305309"/>
                                  <a:ext cx="457176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UDCA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28" name="Szövegdoboz 27">
                                <a:extLst>
                                  <a:ext uri="{FF2B5EF4-FFF2-40B4-BE49-F238E27FC236}">
                                    <a16:creationId xmlns:a16="http://schemas.microsoft.com/office/drawing/2014/main" id="{C5A19352-3835-1B2A-D37C-592DD0B97363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2797923" y="415641"/>
                                <a:ext cx="332142" cy="307777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1400" b="1" dirty="0"/>
                                  <a:t>1.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30" name="Szövegdoboz 29">
                              <a:extLst>
                                <a:ext uri="{FF2B5EF4-FFF2-40B4-BE49-F238E27FC236}">
                                  <a16:creationId xmlns:a16="http://schemas.microsoft.com/office/drawing/2014/main" id="{699F7CBF-82B7-8544-B5CD-1520FFB596FE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6271647" y="416294"/>
                              <a:ext cx="335348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1400" b="1" dirty="0"/>
                                <a:t>2.</a:t>
                              </a:r>
                            </a:p>
                          </p:txBody>
                        </p:sp>
                        <p:sp>
                          <p:nvSpPr>
                            <p:cNvPr id="37" name="Szövegdoboz 36">
                              <a:extLst>
                                <a:ext uri="{FF2B5EF4-FFF2-40B4-BE49-F238E27FC236}">
                                  <a16:creationId xmlns:a16="http://schemas.microsoft.com/office/drawing/2014/main" id="{2055F9B2-F05D-F9C9-6FEF-26453912E94E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0016820" y="415477"/>
                              <a:ext cx="335348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1400" b="1" dirty="0"/>
                                <a:t>3.</a:t>
                              </a:r>
                            </a:p>
                          </p:txBody>
                        </p:sp>
                        <p:sp>
                          <p:nvSpPr>
                            <p:cNvPr id="41" name="Téglalap 40">
                              <a:extLst>
                                <a:ext uri="{FF2B5EF4-FFF2-40B4-BE49-F238E27FC236}">
                                  <a16:creationId xmlns:a16="http://schemas.microsoft.com/office/drawing/2014/main" id="{B5B8A4E9-17EF-C656-2EE4-AD7A24CA4F62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70822" y="474905"/>
                              <a:ext cx="11962095" cy="1999716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style>
                            <a:lnRef idx="2">
                              <a:schemeClr val="accent1">
                                <a:shade val="1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hu-HU"/>
                            </a:p>
                          </p:txBody>
                        </p:sp>
                      </p:grpSp>
                      <p:pic>
                        <p:nvPicPr>
                          <p:cNvPr id="3" name="Kép 2" descr="A képen fehér, fekete, fekete-fehér, képernyőkép látható&#10;&#10;Automatikusan generált leírás">
                            <a:extLst>
                              <a:ext uri="{FF2B5EF4-FFF2-40B4-BE49-F238E27FC236}">
                                <a16:creationId xmlns:a16="http://schemas.microsoft.com/office/drawing/2014/main" id="{B6495CDA-34B8-9F21-62DC-19973F71DD60}"/>
                              </a:ext>
                            </a:extLst>
                          </p:cNvPr>
                          <p:cNvPicPr>
                            <a:picLocks/>
                          </p:cNvPicPr>
                          <p:nvPr/>
                        </p:nvPicPr>
                        <p:blipFill>
                          <a:blip r:embed="rId2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1803420" y="895503"/>
                            <a:ext cx="2340000" cy="540000"/>
                          </a:xfrm>
                          <a:prstGeom prst="rect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</p:pic>
                      <p:sp>
                        <p:nvSpPr>
                          <p:cNvPr id="6" name="Szövegdoboz 5">
                            <a:extLst>
                              <a:ext uri="{FF2B5EF4-FFF2-40B4-BE49-F238E27FC236}">
                                <a16:creationId xmlns:a16="http://schemas.microsoft.com/office/drawing/2014/main" id="{8876D6C1-04E3-23C0-1634-F79A2961A80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494369" y="864284"/>
                            <a:ext cx="348172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250</a:t>
                            </a:r>
                          </a:p>
                        </p:txBody>
                      </p:sp>
                      <p:sp>
                        <p:nvSpPr>
                          <p:cNvPr id="7" name="Szövegdoboz 6">
                            <a:extLst>
                              <a:ext uri="{FF2B5EF4-FFF2-40B4-BE49-F238E27FC236}">
                                <a16:creationId xmlns:a16="http://schemas.microsoft.com/office/drawing/2014/main" id="{98A33858-C99E-79DD-A268-1B1D4C1E86E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494369" y="997579"/>
                            <a:ext cx="348172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130</a:t>
                            </a:r>
                          </a:p>
                        </p:txBody>
                      </p:sp>
                      <p:sp>
                        <p:nvSpPr>
                          <p:cNvPr id="12" name="Szövegdoboz 11">
                            <a:extLst>
                              <a:ext uri="{FF2B5EF4-FFF2-40B4-BE49-F238E27FC236}">
                                <a16:creationId xmlns:a16="http://schemas.microsoft.com/office/drawing/2014/main" id="{3B2D53C7-B094-57A9-2949-B588EBF9D31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495053" y="1177465"/>
                            <a:ext cx="348172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100</a:t>
                            </a:r>
                          </a:p>
                        </p:txBody>
                      </p:sp>
                    </p:grpSp>
                    <p:pic>
                      <p:nvPicPr>
                        <p:cNvPr id="17" name="Kép 16" descr="A képen fehér, fekete, fekete-fehér, monokróm látható&#10;&#10;Automatikusan generált leírás">
                          <a:extLst>
                            <a:ext uri="{FF2B5EF4-FFF2-40B4-BE49-F238E27FC236}">
                              <a16:creationId xmlns:a16="http://schemas.microsoft.com/office/drawing/2014/main" id="{9683FBFC-AD63-0525-AD55-724EADF33FC0}"/>
                            </a:ext>
                          </a:extLst>
                        </p:cNvPr>
                        <p:cNvPicPr>
                          <a:picLocks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96273" y="1742272"/>
                          <a:ext cx="2340000" cy="540000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  <p:sp>
                      <p:nvSpPr>
                        <p:cNvPr id="18" name="Szövegdoboz 17">
                          <a:extLst>
                            <a:ext uri="{FF2B5EF4-FFF2-40B4-BE49-F238E27FC236}">
                              <a16:creationId xmlns:a16="http://schemas.microsoft.com/office/drawing/2014/main" id="{083823AD-4A3A-8E8C-33EB-67B0564AEA6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513226" y="1798789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55</a:t>
                          </a:r>
                        </a:p>
                      </p:txBody>
                    </p:sp>
                    <p:sp>
                      <p:nvSpPr>
                        <p:cNvPr id="24" name="Szövegdoboz 23">
                          <a:extLst>
                            <a:ext uri="{FF2B5EF4-FFF2-40B4-BE49-F238E27FC236}">
                              <a16:creationId xmlns:a16="http://schemas.microsoft.com/office/drawing/2014/main" id="{FC47F4D6-03D6-52D5-018F-5D0886EC142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517465" y="1998711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35</a:t>
                          </a:r>
                        </a:p>
                      </p:txBody>
                    </p:sp>
                  </p:grpSp>
                  <p:pic>
                    <p:nvPicPr>
                      <p:cNvPr id="50" name="Kép 49" descr="A képen fehér, fekete-fehér, fekete, monokróm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E33FC1F4-0A77-D2CC-61C0-BBC34DA5E69B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282450" y="895503"/>
                        <a:ext cx="2340000" cy="54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  <p:sp>
                    <p:nvSpPr>
                      <p:cNvPr id="53" name="Szövegdoboz 52">
                        <a:extLst>
                          <a:ext uri="{FF2B5EF4-FFF2-40B4-BE49-F238E27FC236}">
                            <a16:creationId xmlns:a16="http://schemas.microsoft.com/office/drawing/2014/main" id="{2C52DCB2-ACC4-87D8-C00E-6FBD8E20C8C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69375" y="826376"/>
                        <a:ext cx="34817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250</a:t>
                        </a:r>
                      </a:p>
                    </p:txBody>
                  </p:sp>
                  <p:sp>
                    <p:nvSpPr>
                      <p:cNvPr id="55" name="Szövegdoboz 54">
                        <a:extLst>
                          <a:ext uri="{FF2B5EF4-FFF2-40B4-BE49-F238E27FC236}">
                            <a16:creationId xmlns:a16="http://schemas.microsoft.com/office/drawing/2014/main" id="{5335C720-EA09-1A4D-1BA7-D1A3E0CCB73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69375" y="987952"/>
                        <a:ext cx="34817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130</a:t>
                        </a:r>
                      </a:p>
                    </p:txBody>
                  </p:sp>
                  <p:sp>
                    <p:nvSpPr>
                      <p:cNvPr id="56" name="Szövegdoboz 55">
                        <a:extLst>
                          <a:ext uri="{FF2B5EF4-FFF2-40B4-BE49-F238E27FC236}">
                            <a16:creationId xmlns:a16="http://schemas.microsoft.com/office/drawing/2014/main" id="{D99121B4-863F-C5B3-EFE8-7F25DD07F7B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70059" y="1177265"/>
                        <a:ext cx="34817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100</a:t>
                        </a:r>
                      </a:p>
                    </p:txBody>
                  </p:sp>
                </p:grpSp>
                <p:pic>
                  <p:nvPicPr>
                    <p:cNvPr id="77" name="Kép 76" descr="A képen fekete-fehér, fekete, fehér, monokróm látható&#10;&#10;Automatikusan generált leírás">
                      <a:extLst>
                        <a:ext uri="{FF2B5EF4-FFF2-40B4-BE49-F238E27FC236}">
                          <a16:creationId xmlns:a16="http://schemas.microsoft.com/office/drawing/2014/main" id="{7D748779-C38C-3CDA-A903-583FCC17F136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282450" y="1743760"/>
                      <a:ext cx="2340000" cy="540000"/>
                    </a:xfrm>
                    <a:prstGeom prst="rec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79" name="Szövegdoboz 78">
                      <a:extLst>
                        <a:ext uri="{FF2B5EF4-FFF2-40B4-BE49-F238E27FC236}">
                          <a16:creationId xmlns:a16="http://schemas.microsoft.com/office/drawing/2014/main" id="{41316C43-006B-2754-ADC4-FFAEFE4FBEA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12271" y="1789362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55</a:t>
                      </a:r>
                    </a:p>
                  </p:txBody>
                </p:sp>
                <p:sp>
                  <p:nvSpPr>
                    <p:cNvPr id="82" name="Szövegdoboz 81">
                      <a:extLst>
                        <a:ext uri="{FF2B5EF4-FFF2-40B4-BE49-F238E27FC236}">
                          <a16:creationId xmlns:a16="http://schemas.microsoft.com/office/drawing/2014/main" id="{FFD4D01F-971B-12F0-2A8E-701A23133E8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16510" y="2026992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35</a:t>
                      </a:r>
                    </a:p>
                  </p:txBody>
                </p:sp>
              </p:grpSp>
            </p:grpSp>
            <p:pic>
              <p:nvPicPr>
                <p:cNvPr id="89" name="Kép 88" descr="A képen röntgenfilm, fekete, fekete-fehér, monokróm látható&#10;&#10;Automatikusan generált leírás">
                  <a:extLst>
                    <a:ext uri="{FF2B5EF4-FFF2-40B4-BE49-F238E27FC236}">
                      <a16:creationId xmlns:a16="http://schemas.microsoft.com/office/drawing/2014/main" id="{920B8A7E-4923-36D1-954F-C6AF6128263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40712" y="871563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  <p:sp>
              <p:nvSpPr>
                <p:cNvPr id="90" name="Szövegdoboz 89">
                  <a:extLst>
                    <a:ext uri="{FF2B5EF4-FFF2-40B4-BE49-F238E27FC236}">
                      <a16:creationId xmlns:a16="http://schemas.microsoft.com/office/drawing/2014/main" id="{CBCBDC07-FD17-2917-6E69-B5F5C20545A9}"/>
                    </a:ext>
                  </a:extLst>
                </p:cNvPr>
                <p:cNvSpPr txBox="1"/>
                <p:nvPr/>
              </p:nvSpPr>
              <p:spPr>
                <a:xfrm>
                  <a:off x="9661688" y="632363"/>
                  <a:ext cx="47000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DMSO</a:t>
                  </a:r>
                </a:p>
              </p:txBody>
            </p:sp>
            <p:sp>
              <p:nvSpPr>
                <p:cNvPr id="91" name="Szövegdoboz 90">
                  <a:extLst>
                    <a:ext uri="{FF2B5EF4-FFF2-40B4-BE49-F238E27FC236}">
                      <a16:creationId xmlns:a16="http://schemas.microsoft.com/office/drawing/2014/main" id="{22EABC73-AA77-D09C-E44B-C408A7F58449}"/>
                    </a:ext>
                  </a:extLst>
                </p:cNvPr>
                <p:cNvSpPr txBox="1"/>
                <p:nvPr/>
              </p:nvSpPr>
              <p:spPr>
                <a:xfrm>
                  <a:off x="10437624" y="636676"/>
                  <a:ext cx="45717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UDCA</a:t>
                  </a:r>
                </a:p>
              </p:txBody>
            </p:sp>
            <p:sp>
              <p:nvSpPr>
                <p:cNvPr id="111" name="Szövegdoboz 110">
                  <a:extLst>
                    <a:ext uri="{FF2B5EF4-FFF2-40B4-BE49-F238E27FC236}">
                      <a16:creationId xmlns:a16="http://schemas.microsoft.com/office/drawing/2014/main" id="{36E844E9-B250-44AD-6A55-5AA7270505A5}"/>
                    </a:ext>
                  </a:extLst>
                </p:cNvPr>
                <p:cNvSpPr txBox="1"/>
                <p:nvPr/>
              </p:nvSpPr>
              <p:spPr>
                <a:xfrm>
                  <a:off x="8601967" y="805506"/>
                  <a:ext cx="3481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100</a:t>
                  </a:r>
                </a:p>
              </p:txBody>
            </p:sp>
            <p:sp>
              <p:nvSpPr>
                <p:cNvPr id="114" name="Szövegdoboz 113">
                  <a:extLst>
                    <a:ext uri="{FF2B5EF4-FFF2-40B4-BE49-F238E27FC236}">
                      <a16:creationId xmlns:a16="http://schemas.microsoft.com/office/drawing/2014/main" id="{50962DAD-2130-9495-033B-B5A19F9E2730}"/>
                    </a:ext>
                  </a:extLst>
                </p:cNvPr>
                <p:cNvSpPr txBox="1"/>
                <p:nvPr/>
              </p:nvSpPr>
              <p:spPr>
                <a:xfrm>
                  <a:off x="8629218" y="1098415"/>
                  <a:ext cx="2936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/>
                    <a:t>70</a:t>
                  </a:r>
                </a:p>
              </p:txBody>
            </p:sp>
            <p:pic>
              <p:nvPicPr>
                <p:cNvPr id="120" name="Kép 119" descr="A képen fehér, fekete, fekete-fehér, monokróm látható&#10;&#10;Automatikusan generált leírás">
                  <a:extLst>
                    <a:ext uri="{FF2B5EF4-FFF2-40B4-BE49-F238E27FC236}">
                      <a16:creationId xmlns:a16="http://schemas.microsoft.com/office/drawing/2014/main" id="{62ACCBE9-24E0-AF72-003F-C0B05C502F2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40712" y="1742272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</p:grpSp>
          <p:sp>
            <p:nvSpPr>
              <p:cNvPr id="134" name="Szövegdoboz 133">
                <a:extLst>
                  <a:ext uri="{FF2B5EF4-FFF2-40B4-BE49-F238E27FC236}">
                    <a16:creationId xmlns:a16="http://schemas.microsoft.com/office/drawing/2014/main" id="{C8AF92B7-7CA7-6B97-756D-6CD971EB9F26}"/>
                  </a:ext>
                </a:extLst>
              </p:cNvPr>
              <p:cNvSpPr txBox="1"/>
              <p:nvPr/>
            </p:nvSpPr>
            <p:spPr>
              <a:xfrm>
                <a:off x="8652580" y="1668381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55</a:t>
                </a:r>
              </a:p>
            </p:txBody>
          </p:sp>
          <p:sp>
            <p:nvSpPr>
              <p:cNvPr id="135" name="Szövegdoboz 134">
                <a:extLst>
                  <a:ext uri="{FF2B5EF4-FFF2-40B4-BE49-F238E27FC236}">
                    <a16:creationId xmlns:a16="http://schemas.microsoft.com/office/drawing/2014/main" id="{38E88DF8-0D87-4CEC-E6A5-617F3F2B38AB}"/>
                  </a:ext>
                </a:extLst>
              </p:cNvPr>
              <p:cNvSpPr txBox="1"/>
              <p:nvPr/>
            </p:nvSpPr>
            <p:spPr>
              <a:xfrm>
                <a:off x="8656819" y="1906011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35</a:t>
                </a:r>
              </a:p>
            </p:txBody>
          </p:sp>
          <p:sp>
            <p:nvSpPr>
              <p:cNvPr id="138" name="Szövegdoboz 137">
                <a:extLst>
                  <a:ext uri="{FF2B5EF4-FFF2-40B4-BE49-F238E27FC236}">
                    <a16:creationId xmlns:a16="http://schemas.microsoft.com/office/drawing/2014/main" id="{ED5E94A1-88B2-A8BE-07F7-BD2DF282289B}"/>
                  </a:ext>
                </a:extLst>
              </p:cNvPr>
              <p:cNvSpPr txBox="1"/>
              <p:nvPr/>
            </p:nvSpPr>
            <p:spPr>
              <a:xfrm>
                <a:off x="8649811" y="2113738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25</a:t>
                </a:r>
              </a:p>
            </p:txBody>
          </p:sp>
        </p:grpSp>
      </p:grpSp>
      <p:grpSp>
        <p:nvGrpSpPr>
          <p:cNvPr id="141" name="Csoportba foglalás 140">
            <a:extLst>
              <a:ext uri="{FF2B5EF4-FFF2-40B4-BE49-F238E27FC236}">
                <a16:creationId xmlns:a16="http://schemas.microsoft.com/office/drawing/2014/main" id="{374428CB-1122-8E22-EFF2-D43379F4BD4F}"/>
              </a:ext>
            </a:extLst>
          </p:cNvPr>
          <p:cNvGrpSpPr/>
          <p:nvPr/>
        </p:nvGrpSpPr>
        <p:grpSpPr>
          <a:xfrm>
            <a:off x="68367" y="3473579"/>
            <a:ext cx="11964550" cy="2059995"/>
            <a:chOff x="69594" y="4637361"/>
            <a:chExt cx="11964550" cy="2059995"/>
          </a:xfrm>
        </p:grpSpPr>
        <p:grpSp>
          <p:nvGrpSpPr>
            <p:cNvPr id="128" name="Csoportba foglalás 127">
              <a:extLst>
                <a:ext uri="{FF2B5EF4-FFF2-40B4-BE49-F238E27FC236}">
                  <a16:creationId xmlns:a16="http://schemas.microsoft.com/office/drawing/2014/main" id="{8ED615AE-A29A-1D60-F31B-A92D18753D82}"/>
                </a:ext>
              </a:extLst>
            </p:cNvPr>
            <p:cNvGrpSpPr/>
            <p:nvPr/>
          </p:nvGrpSpPr>
          <p:grpSpPr>
            <a:xfrm>
              <a:off x="69594" y="4637361"/>
              <a:ext cx="11964550" cy="2059995"/>
              <a:chOff x="69594" y="4637361"/>
              <a:chExt cx="11964550" cy="2059995"/>
            </a:xfrm>
          </p:grpSpPr>
          <p:grpSp>
            <p:nvGrpSpPr>
              <p:cNvPr id="124" name="Csoportba foglalás 123">
                <a:extLst>
                  <a:ext uri="{FF2B5EF4-FFF2-40B4-BE49-F238E27FC236}">
                    <a16:creationId xmlns:a16="http://schemas.microsoft.com/office/drawing/2014/main" id="{9B73DF38-E675-6F97-F8B7-72AC8922BC1C}"/>
                  </a:ext>
                </a:extLst>
              </p:cNvPr>
              <p:cNvGrpSpPr/>
              <p:nvPr/>
            </p:nvGrpSpPr>
            <p:grpSpPr>
              <a:xfrm>
                <a:off x="69594" y="4637361"/>
                <a:ext cx="11964550" cy="2059995"/>
                <a:chOff x="69594" y="4637361"/>
                <a:chExt cx="11964550" cy="2059995"/>
              </a:xfrm>
            </p:grpSpPr>
            <p:grpSp>
              <p:nvGrpSpPr>
                <p:cNvPr id="119" name="Csoportba foglalás 118">
                  <a:extLst>
                    <a:ext uri="{FF2B5EF4-FFF2-40B4-BE49-F238E27FC236}">
                      <a16:creationId xmlns:a16="http://schemas.microsoft.com/office/drawing/2014/main" id="{9864CBA2-A3EB-054F-9CAB-73F499F69523}"/>
                    </a:ext>
                  </a:extLst>
                </p:cNvPr>
                <p:cNvGrpSpPr/>
                <p:nvPr/>
              </p:nvGrpSpPr>
              <p:grpSpPr>
                <a:xfrm>
                  <a:off x="69594" y="4637361"/>
                  <a:ext cx="11964550" cy="2059995"/>
                  <a:chOff x="69594" y="4637361"/>
                  <a:chExt cx="11964550" cy="2059995"/>
                </a:xfrm>
              </p:grpSpPr>
              <p:grpSp>
                <p:nvGrpSpPr>
                  <p:cNvPr id="112" name="Csoportba foglalás 111">
                    <a:extLst>
                      <a:ext uri="{FF2B5EF4-FFF2-40B4-BE49-F238E27FC236}">
                        <a16:creationId xmlns:a16="http://schemas.microsoft.com/office/drawing/2014/main" id="{BA2A436E-F44F-75CA-5044-97A5B2860F6B}"/>
                      </a:ext>
                    </a:extLst>
                  </p:cNvPr>
                  <p:cNvGrpSpPr/>
                  <p:nvPr/>
                </p:nvGrpSpPr>
                <p:grpSpPr>
                  <a:xfrm>
                    <a:off x="69594" y="4637361"/>
                    <a:ext cx="11964550" cy="2059995"/>
                    <a:chOff x="69594" y="4637361"/>
                    <a:chExt cx="11964550" cy="2059995"/>
                  </a:xfrm>
                </p:grpSpPr>
                <p:grpSp>
                  <p:nvGrpSpPr>
                    <p:cNvPr id="92" name="Csoportba foglalás 91">
                      <a:extLst>
                        <a:ext uri="{FF2B5EF4-FFF2-40B4-BE49-F238E27FC236}">
                          <a16:creationId xmlns:a16="http://schemas.microsoft.com/office/drawing/2014/main" id="{C26D0769-9316-432F-4A4B-3C6D6AD9130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9594" y="4637361"/>
                      <a:ext cx="11964550" cy="2059995"/>
                      <a:chOff x="69594" y="4637361"/>
                      <a:chExt cx="11964550" cy="2059995"/>
                    </a:xfrm>
                  </p:grpSpPr>
                  <p:grpSp>
                    <p:nvGrpSpPr>
                      <p:cNvPr id="83" name="Csoportba foglalás 82">
                        <a:extLst>
                          <a:ext uri="{FF2B5EF4-FFF2-40B4-BE49-F238E27FC236}">
                            <a16:creationId xmlns:a16="http://schemas.microsoft.com/office/drawing/2014/main" id="{6B03730C-93EF-DAEF-9ADF-7B0D66207DF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9594" y="4637361"/>
                        <a:ext cx="11964550" cy="2059995"/>
                        <a:chOff x="69594" y="4637361"/>
                        <a:chExt cx="11964550" cy="2059995"/>
                      </a:xfrm>
                    </p:grpSpPr>
                    <p:grpSp>
                      <p:nvGrpSpPr>
                        <p:cNvPr id="76" name="Csoportba foglalás 75">
                          <a:extLst>
                            <a:ext uri="{FF2B5EF4-FFF2-40B4-BE49-F238E27FC236}">
                              <a16:creationId xmlns:a16="http://schemas.microsoft.com/office/drawing/2014/main" id="{0B552EB4-4454-0512-FC6F-90C2B645D20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9594" y="4637361"/>
                          <a:ext cx="11964550" cy="2059995"/>
                          <a:chOff x="69594" y="4637361"/>
                          <a:chExt cx="11964550" cy="2059995"/>
                        </a:xfrm>
                      </p:grpSpPr>
                      <p:grpSp>
                        <p:nvGrpSpPr>
                          <p:cNvPr id="72" name="Csoportba foglalás 71">
                            <a:extLst>
                              <a:ext uri="{FF2B5EF4-FFF2-40B4-BE49-F238E27FC236}">
                                <a16:creationId xmlns:a16="http://schemas.microsoft.com/office/drawing/2014/main" id="{B88CC0EF-F664-E708-0069-E7BBFAD4135A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9594" y="4637361"/>
                            <a:ext cx="11964550" cy="2059995"/>
                            <a:chOff x="69594" y="4637361"/>
                            <a:chExt cx="11964550" cy="2059995"/>
                          </a:xfrm>
                        </p:grpSpPr>
                        <p:grpSp>
                          <p:nvGrpSpPr>
                            <p:cNvPr id="66" name="Csoportba foglalás 65">
                              <a:extLst>
                                <a:ext uri="{FF2B5EF4-FFF2-40B4-BE49-F238E27FC236}">
                                  <a16:creationId xmlns:a16="http://schemas.microsoft.com/office/drawing/2014/main" id="{C9AB5220-7D7E-9C55-E57A-1894F0352A7B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9594" y="4637361"/>
                              <a:ext cx="11964550" cy="2059995"/>
                              <a:chOff x="69594" y="4637361"/>
                              <a:chExt cx="11964550" cy="2059995"/>
                            </a:xfrm>
                          </p:grpSpPr>
                          <p:grpSp>
                            <p:nvGrpSpPr>
                              <p:cNvPr id="60" name="Csoportba foglalás 59">
                                <a:extLst>
                                  <a:ext uri="{FF2B5EF4-FFF2-40B4-BE49-F238E27FC236}">
                                    <a16:creationId xmlns:a16="http://schemas.microsoft.com/office/drawing/2014/main" id="{111FA6A2-1FA2-AD2F-C722-F9790ABD263B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9594" y="4637361"/>
                                <a:ext cx="11964550" cy="2059995"/>
                                <a:chOff x="69594" y="4637361"/>
                                <a:chExt cx="11964550" cy="2059995"/>
                              </a:xfrm>
                            </p:grpSpPr>
                            <p:grpSp>
                              <p:nvGrpSpPr>
                                <p:cNvPr id="51" name="Csoportba foglalás 50">
                                  <a:extLst>
                                    <a:ext uri="{FF2B5EF4-FFF2-40B4-BE49-F238E27FC236}">
                                      <a16:creationId xmlns:a16="http://schemas.microsoft.com/office/drawing/2014/main" id="{03796DB4-E3B1-B284-D1AF-1FA06A067869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9594" y="4637361"/>
                                  <a:ext cx="11964550" cy="2059995"/>
                                  <a:chOff x="69594" y="4637361"/>
                                  <a:chExt cx="11964550" cy="2059995"/>
                                </a:xfrm>
                              </p:grpSpPr>
                              <p:grpSp>
                                <p:nvGrpSpPr>
                                  <p:cNvPr id="46" name="Csoportba foglalás 45">
                                    <a:extLst>
                                      <a:ext uri="{FF2B5EF4-FFF2-40B4-BE49-F238E27FC236}">
                                        <a16:creationId xmlns:a16="http://schemas.microsoft.com/office/drawing/2014/main" id="{AE0E7D8E-B81A-33D9-251E-E40D2E2B470E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9594" y="4637361"/>
                                    <a:ext cx="11964550" cy="2059995"/>
                                    <a:chOff x="69594" y="4637361"/>
                                    <a:chExt cx="11964550" cy="2059995"/>
                                  </a:xfrm>
                                </p:grpSpPr>
                                <p:grpSp>
                                  <p:nvGrpSpPr>
                                    <p:cNvPr id="88" name="Csoportba foglalás 87">
                                      <a:extLst>
                                        <a:ext uri="{FF2B5EF4-FFF2-40B4-BE49-F238E27FC236}">
                                          <a16:creationId xmlns:a16="http://schemas.microsoft.com/office/drawing/2014/main" id="{F6D3344F-6D19-78E8-F078-4B1571A19B67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9594" y="4637361"/>
                                      <a:ext cx="11964550" cy="2059995"/>
                                      <a:chOff x="68367" y="414626"/>
                                      <a:chExt cx="11964550" cy="2059995"/>
                                    </a:xfrm>
                                  </p:grpSpPr>
                                  <p:sp>
                                    <p:nvSpPr>
                                      <p:cNvPr id="94" name="Szövegdoboz 93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EF56F145-A78C-4EB9-A2B9-7BBC2F557FD4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68367" y="1048238"/>
                                        <a:ext cx="999857" cy="307777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squar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1400" dirty="0" err="1"/>
                                          <a:t>Slug</a:t>
                                        </a:r>
                                        <a:r>
                                          <a:rPr lang="hu-HU" sz="1400" dirty="0"/>
                                          <a:t>: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95" name="Szövegdoboz 9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48F2F5DA-B5D7-F0B1-CD0B-07BAE4AE718E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68367" y="1938098"/>
                                        <a:ext cx="803304" cy="307777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squar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1400" dirty="0"/>
                                          <a:t>β-</a:t>
                                        </a:r>
                                        <a:r>
                                          <a:rPr lang="hu-HU" sz="1400" dirty="0" err="1"/>
                                          <a:t>actin</a:t>
                                        </a:r>
                                        <a:r>
                                          <a:rPr lang="hu-HU" sz="1400" dirty="0"/>
                                          <a:t>: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108" name="Szövegdoboz 107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62C280E-03E5-6FA1-B193-67805C43336C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2796696" y="416213"/>
                                        <a:ext cx="332142" cy="307777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1400" b="1" dirty="0"/>
                                          <a:t>1.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104" name="Szövegdoboz 103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C668AA5F-3045-FC77-51B9-CBA1090D5A8E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6270420" y="414626"/>
                                        <a:ext cx="335348" cy="307777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1400" b="1" dirty="0"/>
                                          <a:t>2.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102" name="Szövegdoboz 101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270ACB92-1445-C0D2-82BE-5763E70CEA31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9785715" y="577996"/>
                                        <a:ext cx="335348" cy="307777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1400" b="1" dirty="0"/>
                                          <a:t>3.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99" name="Téglalap 98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7B7B409A-7B56-7F5C-1F52-B6F2D064DE56}"/>
                                          </a:ext>
                                        </a:extLst>
                                      </p:cNvPr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70822" y="474905"/>
                                        <a:ext cx="11962095" cy="1999716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style>
                                      <a:lnRef idx="2">
                                        <a:schemeClr val="accent1">
                                          <a:shade val="15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pPr algn="ctr"/>
                                        <a:endParaRPr lang="hu-HU"/>
                                      </a:p>
                                    </p:txBody>
                                  </p:sp>
                                </p:grpSp>
                                <p:pic>
                                  <p:nvPicPr>
                                    <p:cNvPr id="40" name="Kép 39" descr="A képen fekete, monokróm, Monokróm fényképezés, fekete-fehér látható&#10;&#10;Automatikusan generált leírás">
                                      <a:extLst>
                                        <a:ext uri="{FF2B5EF4-FFF2-40B4-BE49-F238E27FC236}">
                                          <a16:creationId xmlns:a16="http://schemas.microsoft.com/office/drawing/2014/main" id="{631758EA-52CF-EB97-5866-CF26560C611F}"/>
                                        </a:ext>
                                      </a:extLst>
                                    </p:cNvPr>
                                    <p:cNvPicPr>
                                      <a:picLocks/>
                                    </p:cNvPicPr>
                                    <p:nvPr/>
                                  </p:nvPicPr>
                                  <p:blipFill>
                                    <a:blip r:embed="rId8">
                                      <a:extLst>
                                        <a:ext uri="{28A0092B-C50C-407E-A947-70E740481C1C}">
                                          <a14:useLocalDpi xmlns:a14="http://schemas.microsoft.com/office/drawing/2010/main" val="0"/>
                                        </a:ext>
                                      </a:extLst>
                                    </a:blip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1761283" y="5154655"/>
                                      <a:ext cx="2340000" cy="540000"/>
                                    </a:xfrm>
                                    <a:prstGeom prst="rect">
                                      <a:avLst/>
                                    </a:prstGeom>
                                    <a:ln w="9525"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</p:pic>
                              </p:grpSp>
                              <p:sp>
                                <p:nvSpPr>
                                  <p:cNvPr id="47" name="Szövegdoboz 46">
                                    <a:extLst>
                                      <a:ext uri="{FF2B5EF4-FFF2-40B4-BE49-F238E27FC236}">
                                        <a16:creationId xmlns:a16="http://schemas.microsoft.com/office/drawing/2014/main" id="{80350FF5-5E8E-44C5-39C7-C24AEDDE64FE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3142831" y="4923882"/>
                                    <a:ext cx="470000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DMSO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48" name="Szövegdoboz 47">
                                    <a:extLst>
                                      <a:ext uri="{FF2B5EF4-FFF2-40B4-BE49-F238E27FC236}">
                                        <a16:creationId xmlns:a16="http://schemas.microsoft.com/office/drawing/2014/main" id="{3DB7FEE4-9CE0-BCB2-E49F-CFDD6803488D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3461662" y="4922123"/>
                                    <a:ext cx="457176" cy="21544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hu-HU" sz="800" dirty="0"/>
                                      <a:t>UDCA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52" name="Szövegdoboz 51">
                                  <a:extLst>
                                    <a:ext uri="{FF2B5EF4-FFF2-40B4-BE49-F238E27FC236}">
                                      <a16:creationId xmlns:a16="http://schemas.microsoft.com/office/drawing/2014/main" id="{E82E1DFA-A03D-A6E4-C621-1E08B8C655CE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461418" y="5103009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35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58" name="Szövegdoboz 57">
                                  <a:extLst>
                                    <a:ext uri="{FF2B5EF4-FFF2-40B4-BE49-F238E27FC236}">
                                      <a16:creationId xmlns:a16="http://schemas.microsoft.com/office/drawing/2014/main" id="{63654472-166F-E378-1CE9-9F5CC38E46BD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1461418" y="5368080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25</a:t>
                                  </a:r>
                                </a:p>
                              </p:txBody>
                            </p:sp>
                          </p:grpSp>
                          <p:pic>
                            <p:nvPicPr>
                              <p:cNvPr id="62" name="Kép 61" descr="A képen fehér, fekete, fekete-fehér, monokróm látható&#10;&#10;Automatikusan generált leírás">
                                <a:extLst>
                                  <a:ext uri="{FF2B5EF4-FFF2-40B4-BE49-F238E27FC236}">
                                    <a16:creationId xmlns:a16="http://schemas.microsoft.com/office/drawing/2014/main" id="{2C7F69C4-7B10-6E9E-BB68-8183AF73B9AD}"/>
                                  </a:ext>
                                </a:extLst>
                              </p:cNvPr>
                              <p:cNvPicPr>
                                <a:picLocks/>
                              </p:cNvPicPr>
                              <p:nvPr/>
                            </p:nvPicPr>
                            <p:blipFill>
                              <a:blip r:embed="rId9">
                                <a:extLst>
                                  <a:ext uri="{28A0092B-C50C-407E-A947-70E740481C1C}">
                                    <a14:useLocalDpi xmlns:a14="http://schemas.microsoft.com/office/drawing/2010/main" val="0"/>
                                  </a:ext>
                                </a:extLst>
                              </a:blip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1756291" y="6053720"/>
                                <a:ext cx="2340000" cy="540000"/>
                              </a:xfrm>
                              <a:prstGeom prst="rect">
                                <a:avLst/>
                              </a:prstGeom>
                              <a:ln w="9525">
                                <a:solidFill>
                                  <a:schemeClr val="tx1"/>
                                </a:solidFill>
                              </a:ln>
                            </p:spPr>
                          </p:pic>
                          <p:sp>
                            <p:nvSpPr>
                              <p:cNvPr id="63" name="Szövegdoboz 62">
                                <a:extLst>
                                  <a:ext uri="{FF2B5EF4-FFF2-40B4-BE49-F238E27FC236}">
                                    <a16:creationId xmlns:a16="http://schemas.microsoft.com/office/drawing/2014/main" id="{14B67A08-93A2-E785-3CCC-3BFC1A01DA59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3144399" y="5830430"/>
                                <a:ext cx="47000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DMSO</a:t>
                                </a:r>
                              </a:p>
                            </p:txBody>
                          </p:sp>
                          <p:sp>
                            <p:nvSpPr>
                              <p:cNvPr id="64" name="Szövegdoboz 63">
                                <a:extLst>
                                  <a:ext uri="{FF2B5EF4-FFF2-40B4-BE49-F238E27FC236}">
                                    <a16:creationId xmlns:a16="http://schemas.microsoft.com/office/drawing/2014/main" id="{E3943EA2-9838-BB4D-7CB5-322DEEED61AF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3463230" y="5828671"/>
                                <a:ext cx="457176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UDCA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69" name="Szövegdoboz 68">
                              <a:extLst>
                                <a:ext uri="{FF2B5EF4-FFF2-40B4-BE49-F238E27FC236}">
                                  <a16:creationId xmlns:a16="http://schemas.microsoft.com/office/drawing/2014/main" id="{3834FA5B-94C3-F7D5-FF69-D6345ADAAC02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445305" y="6005769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55</a:t>
                              </a:r>
                            </a:p>
                          </p:txBody>
                        </p:sp>
                        <p:sp>
                          <p:nvSpPr>
                            <p:cNvPr id="70" name="Szövegdoboz 69">
                              <a:extLst>
                                <a:ext uri="{FF2B5EF4-FFF2-40B4-BE49-F238E27FC236}">
                                  <a16:creationId xmlns:a16="http://schemas.microsoft.com/office/drawing/2014/main" id="{4FFBB0A1-886C-BEAB-62E8-6C9F9E636F7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449544" y="6318815"/>
                              <a:ext cx="293670" cy="21544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hu-HU" sz="800" dirty="0"/>
                                <a:t>35</a:t>
                              </a:r>
                            </a:p>
                          </p:txBody>
                        </p:sp>
                      </p:grpSp>
                      <p:pic>
                        <p:nvPicPr>
                          <p:cNvPr id="75" name="Kép 74" descr="A képen fekete, fekete-fehér, monokróm, Monokróm fényképezés látható&#10;&#10;Automatikusan generált leírás">
                            <a:extLst>
                              <a:ext uri="{FF2B5EF4-FFF2-40B4-BE49-F238E27FC236}">
                                <a16:creationId xmlns:a16="http://schemas.microsoft.com/office/drawing/2014/main" id="{BB2FAC45-3AD6-4EEE-8863-9BE0A099E6E6}"/>
                              </a:ext>
                            </a:extLst>
                          </p:cNvPr>
                          <p:cNvPicPr>
                            <a:picLocks/>
                          </p:cNvPicPr>
                          <p:nvPr/>
                        </p:nvPicPr>
                        <p:blipFill>
                          <a:blip r:embed="rId10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5282450" y="5154655"/>
                            <a:ext cx="2340000" cy="540000"/>
                          </a:xfrm>
                          <a:prstGeom prst="rect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</p:pic>
                    </p:grpSp>
                    <p:sp>
                      <p:nvSpPr>
                        <p:cNvPr id="78" name="Szövegdoboz 77">
                          <a:extLst>
                            <a:ext uri="{FF2B5EF4-FFF2-40B4-BE49-F238E27FC236}">
                              <a16:creationId xmlns:a16="http://schemas.microsoft.com/office/drawing/2014/main" id="{56ECFDB7-4EAC-22FD-729D-D93420C5D54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648886" y="4924185"/>
                          <a:ext cx="47000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DMSO</a:t>
                          </a:r>
                        </a:p>
                      </p:txBody>
                    </p:sp>
                    <p:sp>
                      <p:nvSpPr>
                        <p:cNvPr id="80" name="Szövegdoboz 79">
                          <a:extLst>
                            <a:ext uri="{FF2B5EF4-FFF2-40B4-BE49-F238E27FC236}">
                              <a16:creationId xmlns:a16="http://schemas.microsoft.com/office/drawing/2014/main" id="{C893C6D6-A75C-532D-D200-89BC29075B0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967717" y="4922426"/>
                          <a:ext cx="457176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UDCA</a:t>
                          </a:r>
                        </a:p>
                      </p:txBody>
                    </p:sp>
                  </p:grpSp>
                  <p:sp>
                    <p:nvSpPr>
                      <p:cNvPr id="84" name="Szövegdoboz 83">
                        <a:extLst>
                          <a:ext uri="{FF2B5EF4-FFF2-40B4-BE49-F238E27FC236}">
                            <a16:creationId xmlns:a16="http://schemas.microsoft.com/office/drawing/2014/main" id="{2198C2E6-613A-E20D-A18C-D8A8FE49795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85022" y="5093582"/>
                        <a:ext cx="2936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35</a:t>
                        </a:r>
                      </a:p>
                    </p:txBody>
                  </p:sp>
                  <p:sp>
                    <p:nvSpPr>
                      <p:cNvPr id="87" name="Szövegdoboz 86">
                        <a:extLst>
                          <a:ext uri="{FF2B5EF4-FFF2-40B4-BE49-F238E27FC236}">
                            <a16:creationId xmlns:a16="http://schemas.microsoft.com/office/drawing/2014/main" id="{FF65A2CD-A56F-5FA4-8410-7F9A50C14CC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85022" y="5452923"/>
                        <a:ext cx="29367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hu-HU" sz="800" dirty="0"/>
                          <a:t>25</a:t>
                        </a:r>
                      </a:p>
                    </p:txBody>
                  </p:sp>
                </p:grpSp>
                <p:sp>
                  <p:nvSpPr>
                    <p:cNvPr id="105" name="Szövegdoboz 104">
                      <a:extLst>
                        <a:ext uri="{FF2B5EF4-FFF2-40B4-BE49-F238E27FC236}">
                          <a16:creationId xmlns:a16="http://schemas.microsoft.com/office/drawing/2014/main" id="{645F7801-48C9-BEC1-5EAC-E1B2A7CD761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652378" y="5825935"/>
                      <a:ext cx="47000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DMSO</a:t>
                      </a:r>
                    </a:p>
                  </p:txBody>
                </p:sp>
                <p:sp>
                  <p:nvSpPr>
                    <p:cNvPr id="106" name="Szövegdoboz 105">
                      <a:extLst>
                        <a:ext uri="{FF2B5EF4-FFF2-40B4-BE49-F238E27FC236}">
                          <a16:creationId xmlns:a16="http://schemas.microsoft.com/office/drawing/2014/main" id="{80B7D350-0502-3706-037F-13A2C12F4A8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86124" y="5832270"/>
                      <a:ext cx="45717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UDCA</a:t>
                      </a:r>
                    </a:p>
                  </p:txBody>
                </p:sp>
                <p:pic>
                  <p:nvPicPr>
                    <p:cNvPr id="107" name="Kép 106" descr="A képen fehér, fekete, fekete-fehér, monokróm látható&#10;&#10;Automatikusan generált leírás">
                      <a:extLst>
                        <a:ext uri="{FF2B5EF4-FFF2-40B4-BE49-F238E27FC236}">
                          <a16:creationId xmlns:a16="http://schemas.microsoft.com/office/drawing/2014/main" id="{6ACC2A80-CABC-B9C0-C19D-3E70B463292C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278692" y="6052163"/>
                      <a:ext cx="2340000" cy="540000"/>
                    </a:xfrm>
                    <a:prstGeom prst="rec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09" name="Szövegdoboz 108">
                      <a:extLst>
                        <a:ext uri="{FF2B5EF4-FFF2-40B4-BE49-F238E27FC236}">
                          <a16:creationId xmlns:a16="http://schemas.microsoft.com/office/drawing/2014/main" id="{2DDDA49D-4465-4F31-0256-4D520C5ACA7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95645" y="6108680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55</a:t>
                      </a:r>
                    </a:p>
                  </p:txBody>
                </p:sp>
                <p:sp>
                  <p:nvSpPr>
                    <p:cNvPr id="110" name="Szövegdoboz 109">
                      <a:extLst>
                        <a:ext uri="{FF2B5EF4-FFF2-40B4-BE49-F238E27FC236}">
                          <a16:creationId xmlns:a16="http://schemas.microsoft.com/office/drawing/2014/main" id="{B04606C1-7BDC-423C-4F0C-7A4EB27C0B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99884" y="6308602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35</a:t>
                      </a:r>
                    </a:p>
                  </p:txBody>
                </p:sp>
              </p:grpSp>
              <p:sp>
                <p:nvSpPr>
                  <p:cNvPr id="113" name="Szövegdoboz 112">
                    <a:extLst>
                      <a:ext uri="{FF2B5EF4-FFF2-40B4-BE49-F238E27FC236}">
                        <a16:creationId xmlns:a16="http://schemas.microsoft.com/office/drawing/2014/main" id="{BC390CCB-4680-94F0-DB9B-E4309E2CF6BF}"/>
                      </a:ext>
                    </a:extLst>
                  </p:cNvPr>
                  <p:cNvSpPr txBox="1"/>
                  <p:nvPr/>
                </p:nvSpPr>
                <p:spPr>
                  <a:xfrm>
                    <a:off x="9294768" y="5828549"/>
                    <a:ext cx="4700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DMSO</a:t>
                    </a:r>
                  </a:p>
                </p:txBody>
              </p:sp>
              <p:sp>
                <p:nvSpPr>
                  <p:cNvPr id="115" name="Szövegdoboz 114">
                    <a:extLst>
                      <a:ext uri="{FF2B5EF4-FFF2-40B4-BE49-F238E27FC236}">
                        <a16:creationId xmlns:a16="http://schemas.microsoft.com/office/drawing/2014/main" id="{BD74FC73-12F4-CF03-8ECC-C1BCAD3C4CC2}"/>
                      </a:ext>
                    </a:extLst>
                  </p:cNvPr>
                  <p:cNvSpPr txBox="1"/>
                  <p:nvPr/>
                </p:nvSpPr>
                <p:spPr>
                  <a:xfrm>
                    <a:off x="10486350" y="5834884"/>
                    <a:ext cx="45717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UDCA</a:t>
                    </a:r>
                  </a:p>
                </p:txBody>
              </p:sp>
              <p:pic>
                <p:nvPicPr>
                  <p:cNvPr id="116" name="Kép 115" descr="A képen fekete-fehér, fekete, fehér, monokróm látható&#10;&#10;Automatikusan generált leírás">
                    <a:extLst>
                      <a:ext uri="{FF2B5EF4-FFF2-40B4-BE49-F238E27FC236}">
                        <a16:creationId xmlns:a16="http://schemas.microsoft.com/office/drawing/2014/main" id="{67CF2AF8-3C60-D413-D622-DDCDAAA07794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40712" y="6053604"/>
                    <a:ext cx="2340000" cy="54000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sp>
                <p:nvSpPr>
                  <p:cNvPr id="117" name="Szövegdoboz 116">
                    <a:extLst>
                      <a:ext uri="{FF2B5EF4-FFF2-40B4-BE49-F238E27FC236}">
                        <a16:creationId xmlns:a16="http://schemas.microsoft.com/office/drawing/2014/main" id="{0F2872EA-34FD-16D1-668C-7F5C9FB957A0}"/>
                      </a:ext>
                    </a:extLst>
                  </p:cNvPr>
                  <p:cNvSpPr txBox="1"/>
                  <p:nvPr/>
                </p:nvSpPr>
                <p:spPr>
                  <a:xfrm>
                    <a:off x="8670533" y="6099206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55</a:t>
                    </a:r>
                  </a:p>
                </p:txBody>
              </p:sp>
              <p:sp>
                <p:nvSpPr>
                  <p:cNvPr id="118" name="Szövegdoboz 117">
                    <a:extLst>
                      <a:ext uri="{FF2B5EF4-FFF2-40B4-BE49-F238E27FC236}">
                        <a16:creationId xmlns:a16="http://schemas.microsoft.com/office/drawing/2014/main" id="{B23EB8E1-8508-0B14-3E1D-C94D72EEC412}"/>
                      </a:ext>
                    </a:extLst>
                  </p:cNvPr>
                  <p:cNvSpPr txBox="1"/>
                  <p:nvPr/>
                </p:nvSpPr>
                <p:spPr>
                  <a:xfrm>
                    <a:off x="8674772" y="6336836"/>
                    <a:ext cx="29367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35</a:t>
                    </a:r>
                  </a:p>
                </p:txBody>
              </p:sp>
            </p:grpSp>
            <p:pic>
              <p:nvPicPr>
                <p:cNvPr id="122" name="Kép 121" descr="A képen fekete, fekete-fehér, fehér, homályos látható&#10;&#10;Automatikusan generált leírás">
                  <a:extLst>
                    <a:ext uri="{FF2B5EF4-FFF2-40B4-BE49-F238E27FC236}">
                      <a16:creationId xmlns:a16="http://schemas.microsoft.com/office/drawing/2014/main" id="{1F4B3698-8073-4BEF-A8D6-E2EBEC0206C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50139" y="5150924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</p:grpSp>
          <p:sp>
            <p:nvSpPr>
              <p:cNvPr id="125" name="Szövegdoboz 124">
                <a:extLst>
                  <a:ext uri="{FF2B5EF4-FFF2-40B4-BE49-F238E27FC236}">
                    <a16:creationId xmlns:a16="http://schemas.microsoft.com/office/drawing/2014/main" id="{35A99A15-26BB-07F9-7B68-AF84BBBB1E50}"/>
                  </a:ext>
                </a:extLst>
              </p:cNvPr>
              <p:cNvSpPr txBox="1"/>
              <p:nvPr/>
            </p:nvSpPr>
            <p:spPr>
              <a:xfrm>
                <a:off x="9334044" y="4915721"/>
                <a:ext cx="47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DMSO</a:t>
                </a:r>
              </a:p>
            </p:txBody>
          </p:sp>
          <p:sp>
            <p:nvSpPr>
              <p:cNvPr id="127" name="Szövegdoboz 126">
                <a:extLst>
                  <a:ext uri="{FF2B5EF4-FFF2-40B4-BE49-F238E27FC236}">
                    <a16:creationId xmlns:a16="http://schemas.microsoft.com/office/drawing/2014/main" id="{27637165-052A-3DF1-CB92-380FACB5EAA0}"/>
                  </a:ext>
                </a:extLst>
              </p:cNvPr>
              <p:cNvSpPr txBox="1"/>
              <p:nvPr/>
            </p:nvSpPr>
            <p:spPr>
              <a:xfrm>
                <a:off x="10525626" y="4912629"/>
                <a:ext cx="4571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UDCA</a:t>
                </a:r>
              </a:p>
            </p:txBody>
          </p:sp>
        </p:grpSp>
        <p:sp>
          <p:nvSpPr>
            <p:cNvPr id="136" name="Szövegdoboz 135">
              <a:extLst>
                <a:ext uri="{FF2B5EF4-FFF2-40B4-BE49-F238E27FC236}">
                  <a16:creationId xmlns:a16="http://schemas.microsoft.com/office/drawing/2014/main" id="{004667CE-DC58-A072-53E6-D83162B026C4}"/>
                </a:ext>
              </a:extLst>
            </p:cNvPr>
            <p:cNvSpPr txBox="1"/>
            <p:nvPr/>
          </p:nvSpPr>
          <p:spPr>
            <a:xfrm>
              <a:off x="8652601" y="5087525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35</a:t>
              </a:r>
            </a:p>
          </p:txBody>
        </p:sp>
        <p:sp>
          <p:nvSpPr>
            <p:cNvPr id="137" name="Szövegdoboz 136">
              <a:extLst>
                <a:ext uri="{FF2B5EF4-FFF2-40B4-BE49-F238E27FC236}">
                  <a16:creationId xmlns:a16="http://schemas.microsoft.com/office/drawing/2014/main" id="{8AE3E9F1-347C-3DB1-6FA6-DD58004187CA}"/>
                </a:ext>
              </a:extLst>
            </p:cNvPr>
            <p:cNvSpPr txBox="1"/>
            <p:nvPr/>
          </p:nvSpPr>
          <p:spPr>
            <a:xfrm>
              <a:off x="8652601" y="544686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2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346964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id="{38A938F5-A163-0F79-8D2C-EFFD68AF06FE}"/>
              </a:ext>
            </a:extLst>
          </p:cNvPr>
          <p:cNvSpPr txBox="1"/>
          <p:nvPr/>
        </p:nvSpPr>
        <p:spPr>
          <a:xfrm>
            <a:off x="69594" y="85297"/>
            <a:ext cx="2328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EMT </a:t>
            </a:r>
            <a:r>
              <a:rPr lang="hu-HU" b="1" dirty="0" err="1"/>
              <a:t>markers</a:t>
            </a:r>
            <a:r>
              <a:rPr lang="hu-HU" b="1" dirty="0"/>
              <a:t>:</a:t>
            </a:r>
          </a:p>
        </p:txBody>
      </p:sp>
      <p:grpSp>
        <p:nvGrpSpPr>
          <p:cNvPr id="117" name="Csoportba foglalás 116">
            <a:extLst>
              <a:ext uri="{FF2B5EF4-FFF2-40B4-BE49-F238E27FC236}">
                <a16:creationId xmlns:a16="http://schemas.microsoft.com/office/drawing/2014/main" id="{4345A7D1-B7A8-FEFC-F736-8C92BFBCB76E}"/>
              </a:ext>
            </a:extLst>
          </p:cNvPr>
          <p:cNvGrpSpPr/>
          <p:nvPr/>
        </p:nvGrpSpPr>
        <p:grpSpPr>
          <a:xfrm>
            <a:off x="87222" y="967280"/>
            <a:ext cx="11964550" cy="2068324"/>
            <a:chOff x="87221" y="369090"/>
            <a:chExt cx="11964550" cy="2068324"/>
          </a:xfrm>
        </p:grpSpPr>
        <p:grpSp>
          <p:nvGrpSpPr>
            <p:cNvPr id="113" name="Csoportba foglalás 112">
              <a:extLst>
                <a:ext uri="{FF2B5EF4-FFF2-40B4-BE49-F238E27FC236}">
                  <a16:creationId xmlns:a16="http://schemas.microsoft.com/office/drawing/2014/main" id="{AC90CC4A-0BFB-0F98-4997-F47E7DF0BDF3}"/>
                </a:ext>
              </a:extLst>
            </p:cNvPr>
            <p:cNvGrpSpPr/>
            <p:nvPr/>
          </p:nvGrpSpPr>
          <p:grpSpPr>
            <a:xfrm>
              <a:off x="87221" y="369090"/>
              <a:ext cx="11964550" cy="2068324"/>
              <a:chOff x="87221" y="369090"/>
              <a:chExt cx="11964550" cy="2068324"/>
            </a:xfrm>
          </p:grpSpPr>
          <p:grpSp>
            <p:nvGrpSpPr>
              <p:cNvPr id="109" name="Csoportba foglalás 108">
                <a:extLst>
                  <a:ext uri="{FF2B5EF4-FFF2-40B4-BE49-F238E27FC236}">
                    <a16:creationId xmlns:a16="http://schemas.microsoft.com/office/drawing/2014/main" id="{28755808-7082-97B3-8921-C8F77A9DD10D}"/>
                  </a:ext>
                </a:extLst>
              </p:cNvPr>
              <p:cNvGrpSpPr/>
              <p:nvPr/>
            </p:nvGrpSpPr>
            <p:grpSpPr>
              <a:xfrm>
                <a:off x="87221" y="369090"/>
                <a:ext cx="11964550" cy="2068324"/>
                <a:chOff x="87221" y="369090"/>
                <a:chExt cx="11964550" cy="2068324"/>
              </a:xfrm>
            </p:grpSpPr>
            <p:grpSp>
              <p:nvGrpSpPr>
                <p:cNvPr id="106" name="Csoportba foglalás 105">
                  <a:extLst>
                    <a:ext uri="{FF2B5EF4-FFF2-40B4-BE49-F238E27FC236}">
                      <a16:creationId xmlns:a16="http://schemas.microsoft.com/office/drawing/2014/main" id="{6D3ED07C-ACC9-6714-27C8-369AD27E6AB8}"/>
                    </a:ext>
                  </a:extLst>
                </p:cNvPr>
                <p:cNvGrpSpPr/>
                <p:nvPr/>
              </p:nvGrpSpPr>
              <p:grpSpPr>
                <a:xfrm>
                  <a:off x="87221" y="369090"/>
                  <a:ext cx="11964550" cy="2068324"/>
                  <a:chOff x="87221" y="369090"/>
                  <a:chExt cx="11964550" cy="2068324"/>
                </a:xfrm>
              </p:grpSpPr>
              <p:grpSp>
                <p:nvGrpSpPr>
                  <p:cNvPr id="103" name="Csoportba foglalás 102">
                    <a:extLst>
                      <a:ext uri="{FF2B5EF4-FFF2-40B4-BE49-F238E27FC236}">
                        <a16:creationId xmlns:a16="http://schemas.microsoft.com/office/drawing/2014/main" id="{02D8EE9D-42C9-00AF-114F-560F78CF9C17}"/>
                      </a:ext>
                    </a:extLst>
                  </p:cNvPr>
                  <p:cNvGrpSpPr/>
                  <p:nvPr/>
                </p:nvGrpSpPr>
                <p:grpSpPr>
                  <a:xfrm>
                    <a:off x="87221" y="369090"/>
                    <a:ext cx="11964550" cy="2068324"/>
                    <a:chOff x="87221" y="369090"/>
                    <a:chExt cx="11964550" cy="2068324"/>
                  </a:xfrm>
                </p:grpSpPr>
                <p:grpSp>
                  <p:nvGrpSpPr>
                    <p:cNvPr id="98" name="Csoportba foglalás 97">
                      <a:extLst>
                        <a:ext uri="{FF2B5EF4-FFF2-40B4-BE49-F238E27FC236}">
                          <a16:creationId xmlns:a16="http://schemas.microsoft.com/office/drawing/2014/main" id="{60A7EEB9-D70B-645D-DA41-452C8D8523F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7221" y="369090"/>
                      <a:ext cx="11964550" cy="2068324"/>
                      <a:chOff x="87221" y="369090"/>
                      <a:chExt cx="11964550" cy="2068324"/>
                    </a:xfrm>
                  </p:grpSpPr>
                  <p:grpSp>
                    <p:nvGrpSpPr>
                      <p:cNvPr id="95" name="Csoportba foglalás 94">
                        <a:extLst>
                          <a:ext uri="{FF2B5EF4-FFF2-40B4-BE49-F238E27FC236}">
                            <a16:creationId xmlns:a16="http://schemas.microsoft.com/office/drawing/2014/main" id="{D31FB44C-E236-A4F4-E0A8-4224F83815D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7221" y="369090"/>
                        <a:ext cx="11964550" cy="2068324"/>
                        <a:chOff x="-440691" y="369090"/>
                        <a:chExt cx="11964550" cy="2068324"/>
                      </a:xfrm>
                    </p:grpSpPr>
                    <p:grpSp>
                      <p:nvGrpSpPr>
                        <p:cNvPr id="93" name="Csoportba foglalás 92">
                          <a:extLst>
                            <a:ext uri="{FF2B5EF4-FFF2-40B4-BE49-F238E27FC236}">
                              <a16:creationId xmlns:a16="http://schemas.microsoft.com/office/drawing/2014/main" id="{7ACB27AF-356F-D6F5-404A-614A1A37759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440691" y="369090"/>
                          <a:ext cx="11964550" cy="2068324"/>
                          <a:chOff x="-440691" y="369090"/>
                          <a:chExt cx="11964550" cy="2068324"/>
                        </a:xfrm>
                      </p:grpSpPr>
                      <p:sp>
                        <p:nvSpPr>
                          <p:cNvPr id="83" name="Szövegdoboz 82">
                            <a:extLst>
                              <a:ext uri="{FF2B5EF4-FFF2-40B4-BE49-F238E27FC236}">
                                <a16:creationId xmlns:a16="http://schemas.microsoft.com/office/drawing/2014/main" id="{823F0848-D969-6E58-1037-F02BBD6AD85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763896" y="1564745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84" name="Szövegdoboz 83">
                            <a:extLst>
                              <a:ext uri="{FF2B5EF4-FFF2-40B4-BE49-F238E27FC236}">
                                <a16:creationId xmlns:a16="http://schemas.microsoft.com/office/drawing/2014/main" id="{B1AF861D-857A-7DA8-661A-44FCAD4DFE2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587844" y="1571080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  <p:grpSp>
                        <p:nvGrpSpPr>
                          <p:cNvPr id="90" name="Csoportba foglalás 89">
                            <a:extLst>
                              <a:ext uri="{FF2B5EF4-FFF2-40B4-BE49-F238E27FC236}">
                                <a16:creationId xmlns:a16="http://schemas.microsoft.com/office/drawing/2014/main" id="{2B67A56B-B591-CD76-AECA-5A3938308DC3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-440691" y="369090"/>
                            <a:ext cx="11964550" cy="2068324"/>
                            <a:chOff x="-440691" y="369090"/>
                            <a:chExt cx="11964550" cy="2068324"/>
                          </a:xfrm>
                        </p:grpSpPr>
                        <p:grpSp>
                          <p:nvGrpSpPr>
                            <p:cNvPr id="78" name="Csoportba foglalás 77">
                              <a:extLst>
                                <a:ext uri="{FF2B5EF4-FFF2-40B4-BE49-F238E27FC236}">
                                  <a16:creationId xmlns:a16="http://schemas.microsoft.com/office/drawing/2014/main" id="{E06449FE-795F-96AE-C608-6513D7BBF97F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-440691" y="369090"/>
                              <a:ext cx="11964550" cy="2068324"/>
                              <a:chOff x="-440691" y="369090"/>
                              <a:chExt cx="11964550" cy="2068324"/>
                            </a:xfrm>
                          </p:grpSpPr>
                          <p:grpSp>
                            <p:nvGrpSpPr>
                              <p:cNvPr id="73" name="Csoportba foglalás 72">
                                <a:extLst>
                                  <a:ext uri="{FF2B5EF4-FFF2-40B4-BE49-F238E27FC236}">
                                    <a16:creationId xmlns:a16="http://schemas.microsoft.com/office/drawing/2014/main" id="{A90821E5-123E-2D5D-FE62-3CC4DB18D920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-440691" y="369090"/>
                                <a:ext cx="11964550" cy="2068324"/>
                                <a:chOff x="-440691" y="369090"/>
                                <a:chExt cx="11964550" cy="2068324"/>
                              </a:xfrm>
                            </p:grpSpPr>
                            <p:grpSp>
                              <p:nvGrpSpPr>
                                <p:cNvPr id="60" name="Csoportba foglalás 59">
                                  <a:extLst>
                                    <a:ext uri="{FF2B5EF4-FFF2-40B4-BE49-F238E27FC236}">
                                      <a16:creationId xmlns:a16="http://schemas.microsoft.com/office/drawing/2014/main" id="{1FD14F67-C8C3-0484-EDA4-B1CA0DE5B4C9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-440691" y="369090"/>
                                  <a:ext cx="11964550" cy="2068324"/>
                                  <a:chOff x="-440691" y="369090"/>
                                  <a:chExt cx="11964550" cy="2068324"/>
                                </a:xfrm>
                              </p:grpSpPr>
                              <p:grpSp>
                                <p:nvGrpSpPr>
                                  <p:cNvPr id="38" name="Csoportba foglalás 37">
                                    <a:extLst>
                                      <a:ext uri="{FF2B5EF4-FFF2-40B4-BE49-F238E27FC236}">
                                        <a16:creationId xmlns:a16="http://schemas.microsoft.com/office/drawing/2014/main" id="{63CA55E5-4506-737F-935B-A37E7F5A6095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-440691" y="369090"/>
                                    <a:ext cx="11964550" cy="2068324"/>
                                    <a:chOff x="-440691" y="369090"/>
                                    <a:chExt cx="11964550" cy="2068324"/>
                                  </a:xfrm>
                                </p:grpSpPr>
                                <p:grpSp>
                                  <p:nvGrpSpPr>
                                    <p:cNvPr id="32" name="Csoportba foglalás 31">
                                      <a:extLst>
                                        <a:ext uri="{FF2B5EF4-FFF2-40B4-BE49-F238E27FC236}">
                                          <a16:creationId xmlns:a16="http://schemas.microsoft.com/office/drawing/2014/main" id="{B737454B-18AB-8B44-3542-79A42D270763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-440691" y="369090"/>
                                      <a:ext cx="11964550" cy="2068324"/>
                                      <a:chOff x="-440691" y="369090"/>
                                      <a:chExt cx="11964550" cy="2068324"/>
                                    </a:xfrm>
                                  </p:grpSpPr>
                                  <p:grpSp>
                                    <p:nvGrpSpPr>
                                      <p:cNvPr id="22" name="Csoportba foglalás 21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98E9200D-DCAA-9239-42DD-F0F160EA3E62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-440691" y="369090"/>
                                        <a:ext cx="11964550" cy="2068324"/>
                                        <a:chOff x="-440691" y="369090"/>
                                        <a:chExt cx="11964550" cy="2068324"/>
                                      </a:xfrm>
                                    </p:grpSpPr>
                                    <p:grpSp>
                                      <p:nvGrpSpPr>
                                        <p:cNvPr id="17" name="Csoportba foglalás 16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825C857F-A952-7942-8CBB-DCD26A380D4D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-440691" y="369090"/>
                                          <a:ext cx="11964550" cy="2068324"/>
                                          <a:chOff x="-440691" y="369090"/>
                                          <a:chExt cx="11964550" cy="2068324"/>
                                        </a:xfrm>
                                      </p:grpSpPr>
                                      <p:grpSp>
                                        <p:nvGrpSpPr>
                                          <p:cNvPr id="8" name="Csoportba foglalás 7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34537A32-C9A3-5ED3-5054-B909767F2B49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-440691" y="369090"/>
                                            <a:ext cx="11964550" cy="2068324"/>
                                            <a:chOff x="-440691" y="369090"/>
                                            <a:chExt cx="11964550" cy="2068324"/>
                                          </a:xfrm>
                                        </p:grpSpPr>
                                        <p:grpSp>
                                          <p:nvGrpSpPr>
                                            <p:cNvPr id="42" name="Csoportba foglalás 41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C1BC4136-039D-2823-C992-EE7799EEE208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-440691" y="369090"/>
                                              <a:ext cx="11964550" cy="2068324"/>
                                              <a:chOff x="-440691" y="406297"/>
                                              <a:chExt cx="11964550" cy="2068324"/>
                                            </a:xfrm>
                                          </p:grpSpPr>
                                          <p:sp>
                                            <p:nvSpPr>
                                              <p:cNvPr id="5" name="Szövegdoboz 4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2D15ECA6-3D15-AB1E-0C0A-45893045C96B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-440691" y="1048238"/>
                                                <a:ext cx="1364876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squar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dirty="0"/>
                                                  <a:t>Claudin-1: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4" name="Szövegdoboz 13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55B17E81-B9EA-2BCA-5E17-6EF9A23A7493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-440691" y="1947525"/>
                                                <a:ext cx="1280474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squar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dirty="0"/>
                                                  <a:t>β-</a:t>
                                                </a:r>
                                                <a:r>
                                                  <a:rPr lang="hu-HU" sz="1400" dirty="0" err="1"/>
                                                  <a:t>actin</a:t>
                                                </a:r>
                                                <a:r>
                                                  <a:rPr lang="hu-HU" sz="1400" dirty="0"/>
                                                  <a:t>: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28" name="Szövegdoboz 27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C5A19352-3835-1B2A-D37C-592DD0B97363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2334751" y="417269"/>
                                                <a:ext cx="332142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b="1" dirty="0"/>
                                                  <a:t>1.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30" name="Szövegdoboz 29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699F7CBF-82B7-8544-B5CD-1520FFB596FE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6079586" y="417269"/>
                                                <a:ext cx="335348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b="1" dirty="0"/>
                                                  <a:t>2.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37" name="Szövegdoboz 36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2055F9B2-F05D-F9C9-6FEF-26453912E94E}"/>
                                                  </a:ext>
                                                </a:extLst>
                                              </p:cNvPr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9795330" y="406297"/>
                                                <a:ext cx="335348" cy="307777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non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r>
                                                  <a:rPr lang="hu-HU" sz="1400" b="1" dirty="0"/>
                                                  <a:t>3.</a:t>
                                                </a:r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41" name="Téglalap 40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B5B8A4E9-17EF-C656-2EE4-AD7A24CA4F62}"/>
                                                  </a:ext>
                                                </a:extLst>
                                              </p:cNvPr>
                                              <p:cNvSpPr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-438236" y="474905"/>
                                                <a:ext cx="11962095" cy="1999716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15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/>
                                              <a:p>
                                                <a:pPr algn="ctr"/>
                                                <a:endParaRPr lang="hu-HU"/>
                                              </a:p>
                                            </p:txBody>
                                          </p:sp>
                                        </p:grpSp>
                                        <p:pic>
                                          <p:nvPicPr>
                                            <p:cNvPr id="7" name="Kép 6" descr="A képen monokróm, Monokróm fényképezés, fekete-fehér, fehér látható&#10;&#10;Automatikusan generált leírás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60BED134-10BC-11F8-F558-44BBC103F29C}"/>
                                                </a:ext>
                                              </a:extLst>
                                            </p:cNvPr>
                                            <p:cNvPicPr>
                                              <a:picLocks/>
                                            </p:cNvPicPr>
                                            <p:nvPr/>
                                          </p:nvPicPr>
                                          <p:blipFill>
                                            <a:blip r:embed="rId2">
                                              <a:extLst>
                                                <a:ext uri="{28A0092B-C50C-407E-A947-70E740481C1C}">
                                                  <a14:useLocalDpi xmlns:a14="http://schemas.microsoft.com/office/drawing/2010/main" val="0"/>
                                                </a:ext>
                                              </a:extLst>
                                            </a:blip>
                                            <a:stretch>
                                              <a:fillRect/>
                                            </a:stretch>
                                          </p:blipFill>
                                          <p:spPr>
                                            <a:xfrm>
                                              <a:off x="1282306" y="893510"/>
                                              <a:ext cx="2340000" cy="54000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ln w="9525">
                                              <a:solidFill>
                                                <a:schemeClr val="tx1"/>
                                              </a:solidFill>
                                            </a:ln>
                                          </p:spPr>
                                        </p:pic>
                                      </p:grpSp>
                                      <p:sp>
                                        <p:nvSpPr>
                                          <p:cNvPr id="13" name="Szövegdoboz 12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F242AC96-4E69-377E-AC03-92261DC84E52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3158957" y="656631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6" name="Szövegdoboz 15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CCEFA82D-2194-DA55-EA8F-B13995309D26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2766843" y="662966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18" name="Szövegdoboz 17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3259D7E9-EC20-681E-0C93-F3B985FB6440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979179" y="836036"/>
                                          <a:ext cx="29367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25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9" name="Szövegdoboz 18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BD8D2617-1778-5CD4-22F5-67928092B62A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979179" y="1270793"/>
                                          <a:ext cx="293670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15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26" name="Szövegdoboz 2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6A533E61-AAAA-597B-4D16-582B0EAB12EB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3169952" y="1563178"/>
                                        <a:ext cx="47000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DMSO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27" name="Szövegdoboz 2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51DF17C-018E-E030-F112-F97DDCB3B53D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2758984" y="1569513"/>
                                        <a:ext cx="457176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UDCA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33" name="Szövegdoboz 32">
                                      <a:extLst>
                                        <a:ext uri="{FF2B5EF4-FFF2-40B4-BE49-F238E27FC236}">
                                          <a16:creationId xmlns:a16="http://schemas.microsoft.com/office/drawing/2014/main" id="{864EF04C-30C5-7DB2-3B96-5CFC0EF5CD98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985321" y="1742227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5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36" name="Szövegdoboz 35">
                                      <a:extLst>
                                        <a:ext uri="{FF2B5EF4-FFF2-40B4-BE49-F238E27FC236}">
                                          <a16:creationId xmlns:a16="http://schemas.microsoft.com/office/drawing/2014/main" id="{89FB6C6F-A6E6-8DBA-7EF3-7414B258964C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989560" y="2177821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35</a:t>
                                      </a:r>
                                    </a:p>
                                  </p:txBody>
                                </p:sp>
                              </p:grpSp>
                              <p:pic>
                                <p:nvPicPr>
                                  <p:cNvPr id="55" name="Kép 54" descr="A képen fehér, fekete-fehér, monokróm, hó látható&#10;&#10;Automatikusan generált leírás">
                                    <a:extLst>
                                      <a:ext uri="{FF2B5EF4-FFF2-40B4-BE49-F238E27FC236}">
                                        <a16:creationId xmlns:a16="http://schemas.microsoft.com/office/drawing/2014/main" id="{F3900890-B9C7-B43E-8471-1F172E34D947}"/>
                                      </a:ext>
                                    </a:extLst>
                                  </p:cNvPr>
                                  <p:cNvPicPr>
                                    <a:picLocks/>
                                  </p:cNvPicPr>
                                  <p:nvPr/>
                                </p:nvPicPr>
                                <p:blipFill>
                                  <a:blip r:embed="rId3">
                                    <a:extLst>
                                      <a:ext uri="{28A0092B-C50C-407E-A947-70E740481C1C}">
                                        <a14:useLocalDpi xmlns:a14="http://schemas.microsoft.com/office/drawing/2010/main" val="0"/>
                                      </a:ext>
                                    </a:extLst>
                                  </a:blip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5077260" y="897556"/>
                                    <a:ext cx="2340000" cy="540000"/>
                                  </a:xfrm>
                                  <a:prstGeom prst="rect">
                                    <a:avLst/>
                                  </a:prstGeom>
                                  <a:ln w="9525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</p:pic>
                            </p:grpSp>
                            <p:sp>
                              <p:nvSpPr>
                                <p:cNvPr id="67" name="Szövegdoboz 66">
                                  <a:extLst>
                                    <a:ext uri="{FF2B5EF4-FFF2-40B4-BE49-F238E27FC236}">
                                      <a16:creationId xmlns:a16="http://schemas.microsoft.com/office/drawing/2014/main" id="{0E439274-35BB-BE16-0BCA-40C3BA91AA1B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782363" y="836036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25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72" name="Szövegdoboz 71">
                                  <a:extLst>
                                    <a:ext uri="{FF2B5EF4-FFF2-40B4-BE49-F238E27FC236}">
                                      <a16:creationId xmlns:a16="http://schemas.microsoft.com/office/drawing/2014/main" id="{C9011A5C-768D-8A9C-6C91-21B929DB0011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782363" y="1270793"/>
                                  <a:ext cx="29367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15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74" name="Szövegdoboz 73">
                                <a:extLst>
                                  <a:ext uri="{FF2B5EF4-FFF2-40B4-BE49-F238E27FC236}">
                                    <a16:creationId xmlns:a16="http://schemas.microsoft.com/office/drawing/2014/main" id="{1DC9AA07-0F60-F7BA-C859-ED3F1F74AB7C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5762328" y="677053"/>
                                <a:ext cx="470000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DMSO</a:t>
                                </a:r>
                              </a:p>
                            </p:txBody>
                          </p:sp>
                          <p:sp>
                            <p:nvSpPr>
                              <p:cNvPr id="76" name="Szövegdoboz 75">
                                <a:extLst>
                                  <a:ext uri="{FF2B5EF4-FFF2-40B4-BE49-F238E27FC236}">
                                    <a16:creationId xmlns:a16="http://schemas.microsoft.com/office/drawing/2014/main" id="{97B57E67-086B-A601-B5D0-C7EE547F12A3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6557995" y="683388"/>
                                <a:ext cx="457176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UDCA</a:t>
                                </a:r>
                              </a:p>
                            </p:txBody>
                          </p:sp>
                        </p:grpSp>
                        <p:pic>
                          <p:nvPicPr>
                            <p:cNvPr id="88" name="Kép 87" descr="A képen fehér, fekete, klarinét, síp látható&#10;&#10;Automatikusan generált leírás">
                              <a:extLst>
                                <a:ext uri="{FF2B5EF4-FFF2-40B4-BE49-F238E27FC236}">
                                  <a16:creationId xmlns:a16="http://schemas.microsoft.com/office/drawing/2014/main" id="{72A30881-D190-6D13-773E-E12C2823A713}"/>
                                </a:ext>
                              </a:extLst>
                            </p:cNvPr>
                            <p:cNvPicPr>
                              <a:picLocks/>
                            </p:cNvPicPr>
                            <p:nvPr/>
                          </p:nvPicPr>
                          <p:blipFill>
                            <a:blip r:embed="rId4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076033" y="1804789"/>
                              <a:ext cx="2340000" cy="540000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grpSp>
                    </p:grpSp>
                    <p:sp>
                      <p:nvSpPr>
                        <p:cNvPr id="94" name="Szövegdoboz 93">
                          <a:extLst>
                            <a:ext uri="{FF2B5EF4-FFF2-40B4-BE49-F238E27FC236}">
                              <a16:creationId xmlns:a16="http://schemas.microsoft.com/office/drawing/2014/main" id="{DF07B953-1FC2-8826-FD84-4AEF5C717A3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757618" y="1790930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55</a:t>
                          </a:r>
                        </a:p>
                      </p:txBody>
                    </p:sp>
                  </p:grpSp>
                  <p:pic>
                    <p:nvPicPr>
                      <p:cNvPr id="97" name="Kép 96" descr="A képen fekete, fehér, fekete-fehér, monokróm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3D9CEA90-3CB5-661B-19DC-CF833A42AF86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810218" y="1811096"/>
                        <a:ext cx="2340000" cy="54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</p:grpSp>
                <p:pic>
                  <p:nvPicPr>
                    <p:cNvPr id="100" name="Kép 99" descr="A képen fehér, fekete, fekete-fehér, monokróm látható&#10;&#10;Automatikusan generált leírás">
                      <a:extLst>
                        <a:ext uri="{FF2B5EF4-FFF2-40B4-BE49-F238E27FC236}">
                          <a16:creationId xmlns:a16="http://schemas.microsoft.com/office/drawing/2014/main" id="{50C81066-47C7-3C7B-04BE-59B903D7EFC2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9269248" y="893510"/>
                      <a:ext cx="2340000" cy="540000"/>
                    </a:xfrm>
                    <a:prstGeom prst="rec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01" name="Szövegdoboz 100">
                      <a:extLst>
                        <a:ext uri="{FF2B5EF4-FFF2-40B4-BE49-F238E27FC236}">
                          <a16:creationId xmlns:a16="http://schemas.microsoft.com/office/drawing/2014/main" id="{10AFC1A4-6998-4F85-818D-853AE6B0E45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950595" y="865885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25</a:t>
                      </a:r>
                    </a:p>
                  </p:txBody>
                </p:sp>
                <p:sp>
                  <p:nvSpPr>
                    <p:cNvPr id="102" name="Szövegdoboz 101">
                      <a:extLst>
                        <a:ext uri="{FF2B5EF4-FFF2-40B4-BE49-F238E27FC236}">
                          <a16:creationId xmlns:a16="http://schemas.microsoft.com/office/drawing/2014/main" id="{3C7E35DE-80BF-D30A-5516-84CEA16851C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950595" y="1272361"/>
                      <a:ext cx="29367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15</a:t>
                      </a:r>
                    </a:p>
                  </p:txBody>
                </p:sp>
              </p:grpSp>
              <p:sp>
                <p:nvSpPr>
                  <p:cNvPr id="104" name="Szövegdoboz 103">
                    <a:extLst>
                      <a:ext uri="{FF2B5EF4-FFF2-40B4-BE49-F238E27FC236}">
                        <a16:creationId xmlns:a16="http://schemas.microsoft.com/office/drawing/2014/main" id="{959FB684-D2A7-9DDD-E1BD-79B6274B638A}"/>
                      </a:ext>
                    </a:extLst>
                  </p:cNvPr>
                  <p:cNvSpPr txBox="1"/>
                  <p:nvPr/>
                </p:nvSpPr>
                <p:spPr>
                  <a:xfrm>
                    <a:off x="9845719" y="678621"/>
                    <a:ext cx="47000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DMSO</a:t>
                    </a:r>
                  </a:p>
                </p:txBody>
              </p:sp>
              <p:sp>
                <p:nvSpPr>
                  <p:cNvPr id="105" name="Szövegdoboz 104">
                    <a:extLst>
                      <a:ext uri="{FF2B5EF4-FFF2-40B4-BE49-F238E27FC236}">
                        <a16:creationId xmlns:a16="http://schemas.microsoft.com/office/drawing/2014/main" id="{13F8A7CE-E504-0A4A-7B03-65160046A736}"/>
                      </a:ext>
                    </a:extLst>
                  </p:cNvPr>
                  <p:cNvSpPr txBox="1"/>
                  <p:nvPr/>
                </p:nvSpPr>
                <p:spPr>
                  <a:xfrm>
                    <a:off x="10575397" y="675529"/>
                    <a:ext cx="45717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UDCA</a:t>
                    </a:r>
                  </a:p>
                </p:txBody>
              </p:sp>
            </p:grpSp>
            <p:pic>
              <p:nvPicPr>
                <p:cNvPr id="108" name="Kép 107" descr="A képen fehér, fekete, fekete-fehér, monokróm látható&#10;&#10;Automatikusan generált leírás">
                  <a:extLst>
                    <a:ext uri="{FF2B5EF4-FFF2-40B4-BE49-F238E27FC236}">
                      <a16:creationId xmlns:a16="http://schemas.microsoft.com/office/drawing/2014/main" id="{D90AE9C1-59E0-3DF6-9717-1012797D4A1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269248" y="1812329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</p:grpSp>
          <p:sp>
            <p:nvSpPr>
              <p:cNvPr id="110" name="Szövegdoboz 109">
                <a:extLst>
                  <a:ext uri="{FF2B5EF4-FFF2-40B4-BE49-F238E27FC236}">
                    <a16:creationId xmlns:a16="http://schemas.microsoft.com/office/drawing/2014/main" id="{89D6B673-AEDD-2CFC-1F56-CC9F620DB8EF}"/>
                  </a:ext>
                </a:extLst>
              </p:cNvPr>
              <p:cNvSpPr txBox="1"/>
              <p:nvPr/>
            </p:nvSpPr>
            <p:spPr>
              <a:xfrm>
                <a:off x="8961977" y="1743795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55</a:t>
                </a:r>
              </a:p>
            </p:txBody>
          </p:sp>
          <p:sp>
            <p:nvSpPr>
              <p:cNvPr id="112" name="Szövegdoboz 111">
                <a:extLst>
                  <a:ext uri="{FF2B5EF4-FFF2-40B4-BE49-F238E27FC236}">
                    <a16:creationId xmlns:a16="http://schemas.microsoft.com/office/drawing/2014/main" id="{658BDA1F-3AC1-8A3B-DFFA-21248EBB2172}"/>
                  </a:ext>
                </a:extLst>
              </p:cNvPr>
              <p:cNvSpPr txBox="1"/>
              <p:nvPr/>
            </p:nvSpPr>
            <p:spPr>
              <a:xfrm>
                <a:off x="8966216" y="2179389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35</a:t>
                </a:r>
              </a:p>
            </p:txBody>
          </p:sp>
        </p:grpSp>
        <p:sp>
          <p:nvSpPr>
            <p:cNvPr id="115" name="Szövegdoboz 114">
              <a:extLst>
                <a:ext uri="{FF2B5EF4-FFF2-40B4-BE49-F238E27FC236}">
                  <a16:creationId xmlns:a16="http://schemas.microsoft.com/office/drawing/2014/main" id="{F6F404EE-21E6-C31E-1C5A-BF29F893CCD1}"/>
                </a:ext>
              </a:extLst>
            </p:cNvPr>
            <p:cNvSpPr txBox="1"/>
            <p:nvPr/>
          </p:nvSpPr>
          <p:spPr>
            <a:xfrm>
              <a:off x="9866141" y="1594593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DMSO</a:t>
              </a:r>
            </a:p>
          </p:txBody>
        </p:sp>
        <p:sp>
          <p:nvSpPr>
            <p:cNvPr id="116" name="Szövegdoboz 115">
              <a:extLst>
                <a:ext uri="{FF2B5EF4-FFF2-40B4-BE49-F238E27FC236}">
                  <a16:creationId xmlns:a16="http://schemas.microsoft.com/office/drawing/2014/main" id="{7C5A4B52-BF90-F04D-BD73-B6924AF6E075}"/>
                </a:ext>
              </a:extLst>
            </p:cNvPr>
            <p:cNvSpPr txBox="1"/>
            <p:nvPr/>
          </p:nvSpPr>
          <p:spPr>
            <a:xfrm>
              <a:off x="10595819" y="1591501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UDCA</a:t>
              </a:r>
            </a:p>
          </p:txBody>
        </p:sp>
      </p:grpSp>
      <p:pic>
        <p:nvPicPr>
          <p:cNvPr id="119" name="Kép 118" descr="A képen fekete, fekete-fehér, monokróm, fehér látható&#10;&#10;Automatikusan generált leírás">
            <a:extLst>
              <a:ext uri="{FF2B5EF4-FFF2-40B4-BE49-F238E27FC236}">
                <a16:creationId xmlns:a16="http://schemas.microsoft.com/office/drawing/2014/main" id="{CDF2C505-955F-70E9-470F-CF3C8F7194E7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6870" y="3597789"/>
            <a:ext cx="2340000" cy="54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grpSp>
        <p:nvGrpSpPr>
          <p:cNvPr id="173" name="Csoportba foglalás 172">
            <a:extLst>
              <a:ext uri="{FF2B5EF4-FFF2-40B4-BE49-F238E27FC236}">
                <a16:creationId xmlns:a16="http://schemas.microsoft.com/office/drawing/2014/main" id="{25F5C4E4-BD4D-EF4C-6EFC-35F4E1AB29C9}"/>
              </a:ext>
            </a:extLst>
          </p:cNvPr>
          <p:cNvGrpSpPr/>
          <p:nvPr/>
        </p:nvGrpSpPr>
        <p:grpSpPr>
          <a:xfrm>
            <a:off x="69594" y="3110699"/>
            <a:ext cx="11964551" cy="2054876"/>
            <a:chOff x="69593" y="2512509"/>
            <a:chExt cx="11964551" cy="2054876"/>
          </a:xfrm>
        </p:grpSpPr>
        <p:grpSp>
          <p:nvGrpSpPr>
            <p:cNvPr id="171" name="Csoportba foglalás 170">
              <a:extLst>
                <a:ext uri="{FF2B5EF4-FFF2-40B4-BE49-F238E27FC236}">
                  <a16:creationId xmlns:a16="http://schemas.microsoft.com/office/drawing/2014/main" id="{56ED152D-E83F-6FD6-43E8-F521C120918F}"/>
                </a:ext>
              </a:extLst>
            </p:cNvPr>
            <p:cNvGrpSpPr/>
            <p:nvPr/>
          </p:nvGrpSpPr>
          <p:grpSpPr>
            <a:xfrm>
              <a:off x="69593" y="2512509"/>
              <a:ext cx="11964551" cy="2054876"/>
              <a:chOff x="69593" y="2512509"/>
              <a:chExt cx="11964551" cy="2054876"/>
            </a:xfrm>
          </p:grpSpPr>
          <p:grpSp>
            <p:nvGrpSpPr>
              <p:cNvPr id="168" name="Csoportba foglalás 167">
                <a:extLst>
                  <a:ext uri="{FF2B5EF4-FFF2-40B4-BE49-F238E27FC236}">
                    <a16:creationId xmlns:a16="http://schemas.microsoft.com/office/drawing/2014/main" id="{698FA60F-131F-68EA-691D-957C779A2001}"/>
                  </a:ext>
                </a:extLst>
              </p:cNvPr>
              <p:cNvGrpSpPr/>
              <p:nvPr/>
            </p:nvGrpSpPr>
            <p:grpSpPr>
              <a:xfrm>
                <a:off x="69593" y="2512509"/>
                <a:ext cx="11964551" cy="2054876"/>
                <a:chOff x="69593" y="2512509"/>
                <a:chExt cx="11964551" cy="2054876"/>
              </a:xfrm>
            </p:grpSpPr>
            <p:grpSp>
              <p:nvGrpSpPr>
                <p:cNvPr id="165" name="Csoportba foglalás 164">
                  <a:extLst>
                    <a:ext uri="{FF2B5EF4-FFF2-40B4-BE49-F238E27FC236}">
                      <a16:creationId xmlns:a16="http://schemas.microsoft.com/office/drawing/2014/main" id="{2E494FA4-9236-F679-EC6B-78757B958491}"/>
                    </a:ext>
                  </a:extLst>
                </p:cNvPr>
                <p:cNvGrpSpPr/>
                <p:nvPr/>
              </p:nvGrpSpPr>
              <p:grpSpPr>
                <a:xfrm>
                  <a:off x="69593" y="2512509"/>
                  <a:ext cx="11964551" cy="2054876"/>
                  <a:chOff x="69593" y="2512509"/>
                  <a:chExt cx="11964551" cy="2054876"/>
                </a:xfrm>
              </p:grpSpPr>
              <p:grpSp>
                <p:nvGrpSpPr>
                  <p:cNvPr id="162" name="Csoportba foglalás 161">
                    <a:extLst>
                      <a:ext uri="{FF2B5EF4-FFF2-40B4-BE49-F238E27FC236}">
                        <a16:creationId xmlns:a16="http://schemas.microsoft.com/office/drawing/2014/main" id="{591EC4BE-936B-BB0E-8CF0-4A514185F91E}"/>
                      </a:ext>
                    </a:extLst>
                  </p:cNvPr>
                  <p:cNvGrpSpPr/>
                  <p:nvPr/>
                </p:nvGrpSpPr>
                <p:grpSpPr>
                  <a:xfrm>
                    <a:off x="69593" y="2512509"/>
                    <a:ext cx="11964551" cy="2054876"/>
                    <a:chOff x="69593" y="2512509"/>
                    <a:chExt cx="11964551" cy="2054876"/>
                  </a:xfrm>
                </p:grpSpPr>
                <p:grpSp>
                  <p:nvGrpSpPr>
                    <p:cNvPr id="159" name="Csoportba foglalás 158">
                      <a:extLst>
                        <a:ext uri="{FF2B5EF4-FFF2-40B4-BE49-F238E27FC236}">
                          <a16:creationId xmlns:a16="http://schemas.microsoft.com/office/drawing/2014/main" id="{063D404A-4DEE-6DF0-DCBE-019F1202339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9593" y="2512509"/>
                      <a:ext cx="11964551" cy="2054876"/>
                      <a:chOff x="69593" y="2512509"/>
                      <a:chExt cx="11964551" cy="2054876"/>
                    </a:xfrm>
                  </p:grpSpPr>
                  <p:grpSp>
                    <p:nvGrpSpPr>
                      <p:cNvPr id="153" name="Csoportba foglalás 152">
                        <a:extLst>
                          <a:ext uri="{FF2B5EF4-FFF2-40B4-BE49-F238E27FC236}">
                            <a16:creationId xmlns:a16="http://schemas.microsoft.com/office/drawing/2014/main" id="{0FA7B30D-B081-DDFB-28D8-AB1E17FF479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9593" y="2512509"/>
                        <a:ext cx="11964551" cy="2054876"/>
                        <a:chOff x="69593" y="2512509"/>
                        <a:chExt cx="11964551" cy="2054876"/>
                      </a:xfrm>
                    </p:grpSpPr>
                    <p:grpSp>
                      <p:nvGrpSpPr>
                        <p:cNvPr id="150" name="Csoportba foglalás 149">
                          <a:extLst>
                            <a:ext uri="{FF2B5EF4-FFF2-40B4-BE49-F238E27FC236}">
                              <a16:creationId xmlns:a16="http://schemas.microsoft.com/office/drawing/2014/main" id="{C454C61C-751D-F1BC-4FE1-983850C0C90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69593" y="2512509"/>
                          <a:ext cx="11964551" cy="2054876"/>
                          <a:chOff x="69593" y="2512509"/>
                          <a:chExt cx="11964551" cy="2054876"/>
                        </a:xfrm>
                      </p:grpSpPr>
                      <p:grpSp>
                        <p:nvGrpSpPr>
                          <p:cNvPr id="147" name="Csoportba foglalás 146">
                            <a:extLst>
                              <a:ext uri="{FF2B5EF4-FFF2-40B4-BE49-F238E27FC236}">
                                <a16:creationId xmlns:a16="http://schemas.microsoft.com/office/drawing/2014/main" id="{BF7E34C2-A481-795F-2E01-2312B5E89572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69593" y="2512509"/>
                            <a:ext cx="11964551" cy="2054876"/>
                            <a:chOff x="69593" y="2512509"/>
                            <a:chExt cx="11964551" cy="2054876"/>
                          </a:xfrm>
                        </p:grpSpPr>
                        <p:grpSp>
                          <p:nvGrpSpPr>
                            <p:cNvPr id="144" name="Csoportba foglalás 143">
                              <a:extLst>
                                <a:ext uri="{FF2B5EF4-FFF2-40B4-BE49-F238E27FC236}">
                                  <a16:creationId xmlns:a16="http://schemas.microsoft.com/office/drawing/2014/main" id="{FD41DC84-B172-06CC-0870-7943A82CA311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69593" y="2512509"/>
                              <a:ext cx="11964551" cy="2054876"/>
                              <a:chOff x="69593" y="2512509"/>
                              <a:chExt cx="11964551" cy="2054876"/>
                            </a:xfrm>
                          </p:grpSpPr>
                          <p:grpSp>
                            <p:nvGrpSpPr>
                              <p:cNvPr id="141" name="Csoportba foglalás 140">
                                <a:extLst>
                                  <a:ext uri="{FF2B5EF4-FFF2-40B4-BE49-F238E27FC236}">
                                    <a16:creationId xmlns:a16="http://schemas.microsoft.com/office/drawing/2014/main" id="{9D23AA19-FD70-1DD1-783A-0DD36B165937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9593" y="2512509"/>
                                <a:ext cx="11964551" cy="2054876"/>
                                <a:chOff x="69593" y="2512509"/>
                                <a:chExt cx="11964551" cy="2054876"/>
                              </a:xfrm>
                            </p:grpSpPr>
                            <p:grpSp>
                              <p:nvGrpSpPr>
                                <p:cNvPr id="138" name="Csoportba foglalás 137">
                                  <a:extLst>
                                    <a:ext uri="{FF2B5EF4-FFF2-40B4-BE49-F238E27FC236}">
                                      <a16:creationId xmlns:a16="http://schemas.microsoft.com/office/drawing/2014/main" id="{5792C15D-68C5-DFED-5031-1A2DF001ED7C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9593" y="2512509"/>
                                  <a:ext cx="11964551" cy="2054876"/>
                                  <a:chOff x="69593" y="2512509"/>
                                  <a:chExt cx="11964551" cy="2054876"/>
                                </a:xfrm>
                              </p:grpSpPr>
                              <p:grpSp>
                                <p:nvGrpSpPr>
                                  <p:cNvPr id="135" name="Csoportba foglalás 134">
                                    <a:extLst>
                                      <a:ext uri="{FF2B5EF4-FFF2-40B4-BE49-F238E27FC236}">
                                        <a16:creationId xmlns:a16="http://schemas.microsoft.com/office/drawing/2014/main" id="{911D4E9F-8EC2-9E05-18C0-786F7B4E1ECD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9593" y="2512509"/>
                                    <a:ext cx="11964551" cy="2054876"/>
                                    <a:chOff x="69593" y="2512509"/>
                                    <a:chExt cx="11964551" cy="2054876"/>
                                  </a:xfrm>
                                </p:grpSpPr>
                                <p:grpSp>
                                  <p:nvGrpSpPr>
                                    <p:cNvPr id="132" name="Csoportba foglalás 131">
                                      <a:extLst>
                                        <a:ext uri="{FF2B5EF4-FFF2-40B4-BE49-F238E27FC236}">
                                          <a16:creationId xmlns:a16="http://schemas.microsoft.com/office/drawing/2014/main" id="{EFB2B658-DBFA-55A7-4C2A-E1361F9AA22D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69593" y="2512509"/>
                                      <a:ext cx="11964551" cy="2054876"/>
                                      <a:chOff x="69593" y="2512509"/>
                                      <a:chExt cx="11964551" cy="2054876"/>
                                    </a:xfrm>
                                  </p:grpSpPr>
                                  <p:grpSp>
                                    <p:nvGrpSpPr>
                                      <p:cNvPr id="127" name="Csoportba foglalás 12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F6AA529B-9135-17A7-EFFB-4E3A5EB5FD9E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69593" y="2512509"/>
                                        <a:ext cx="11964551" cy="2054876"/>
                                        <a:chOff x="69593" y="2512509"/>
                                        <a:chExt cx="11964551" cy="2054876"/>
                                      </a:xfrm>
                                    </p:grpSpPr>
                                    <p:grpSp>
                                      <p:nvGrpSpPr>
                                        <p:cNvPr id="124" name="Csoportba foglalás 123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4C5F2635-5B8B-7C8B-2DF8-3611D2328EDB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69593" y="2512509"/>
                                          <a:ext cx="11964551" cy="2054876"/>
                                          <a:chOff x="69593" y="2512509"/>
                                          <a:chExt cx="11964551" cy="2054876"/>
                                        </a:xfrm>
                                      </p:grpSpPr>
                                      <p:grpSp>
                                        <p:nvGrpSpPr>
                                          <p:cNvPr id="43" name="Csoportba foglalás 42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5733D2FB-2DC7-A52B-52F2-86DEA22FA11C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69593" y="2512509"/>
                                            <a:ext cx="11964551" cy="2054876"/>
                                            <a:chOff x="68366" y="419745"/>
                                            <a:chExt cx="11964551" cy="2054876"/>
                                          </a:xfrm>
                                        </p:grpSpPr>
                                        <p:sp>
                                          <p:nvSpPr>
                                            <p:cNvPr id="44" name="Szövegdoboz 43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192360AF-9B4D-07C0-69D9-9D4B9F2D9575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8367" y="963402"/>
                                              <a:ext cx="999857" cy="307777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1400" dirty="0"/>
                                                <a:t>ZO-1: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45" name="Szövegdoboz 44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9F69B1C1-A029-B6E6-5879-C80CB14AC6E2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8366" y="1975805"/>
                                              <a:ext cx="1298101" cy="307777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1400" dirty="0"/>
                                                <a:t>β-</a:t>
                                              </a:r>
                                              <a:r>
                                                <a:rPr lang="hu-HU" sz="1400" dirty="0" err="1"/>
                                                <a:t>actin</a:t>
                                              </a:r>
                                              <a:r>
                                                <a:rPr lang="hu-HU" sz="1400" dirty="0"/>
                                                <a:t>: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65" name="Szövegdoboz 64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749D704C-7DF4-04E1-8398-242EF9E268F2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2861436" y="424107"/>
                                              <a:ext cx="332142" cy="307777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1400" b="1" dirty="0"/>
                                                <a:t>1.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57" name="Szövegdoboz 56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36327FCF-C64E-A4AF-6AAD-8F5C7E40787E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606271" y="419745"/>
                                              <a:ext cx="335348" cy="307777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1400" b="1" dirty="0"/>
                                                <a:t>2.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54" name="Szövegdoboz 53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45E0954E-F720-D6DC-28A2-EE23352E491D}"/>
                                                </a:ext>
                                              </a:extLst>
                                            </p:cNvPr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0322015" y="426291"/>
                                              <a:ext cx="335348" cy="307777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non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r>
                                                <a:rPr lang="hu-HU" sz="1400" b="1" dirty="0"/>
                                                <a:t>3.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49" name="Téglalap 48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6B9CFD71-3E98-F54A-5DA3-B922DB367C4D}"/>
                                                </a:ext>
                                              </a:extLst>
                                            </p:cNvPr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70822" y="474905"/>
                                              <a:ext cx="11962095" cy="1999716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15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hu-HU"/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121" name="Szövegdoboz 12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AA1C2F2B-A0D4-E5B6-6F44-F933CC04C820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3735572" y="2769804"/>
                                            <a:ext cx="470000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DMSO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22" name="Szövegdoboz 121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99A607FD-F337-F56C-E651-AD607C7FED3F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3343458" y="2776139"/>
                                            <a:ext cx="457176" cy="215444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hu-HU" sz="800" dirty="0"/>
                                              <a:t>UDCA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125" name="Szövegdoboz 124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B075730F-E7F7-425C-7C6E-AD28C8787536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1470951" y="3071764"/>
                                          <a:ext cx="348172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250</a:t>
                                          </a:r>
                                        </a:p>
                                      </p:txBody>
                                    </p:sp>
                                    <p:sp>
                                      <p:nvSpPr>
                                        <p:cNvPr id="126" name="Szövegdoboz 125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39AF0266-E8EE-D798-E289-17534133D255}"/>
                                            </a:ext>
                                          </a:extLst>
                                        </p:cNvPr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1452097" y="3346262"/>
                                          <a:ext cx="348172" cy="215444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none" rtlCol="0">
                                          <a:spAutoFit/>
                                        </a:bodyPr>
                                        <a:lstStyle/>
                                        <a:p>
                                          <a:r>
                                            <a:rPr lang="hu-HU" sz="800" dirty="0"/>
                                            <a:t>130</a:t>
                                          </a:r>
                                        </a:p>
                                      </p:txBody>
                                    </p:sp>
                                  </p:grpSp>
                                  <p:pic>
                                    <p:nvPicPr>
                                      <p:cNvPr id="129" name="Kép 128" descr="A képen fekete, fehér, fekete-fehér, monokróm látható&#10;&#10;Automatikusan generált leírás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AD023F94-5883-A645-C180-68938DE93568}"/>
                                          </a:ext>
                                        </a:extLst>
                                      </p:cNvPr>
                                      <p:cNvPicPr>
                                        <a:picLocks/>
                                      </p:cNvPicPr>
                                      <p:nvPr/>
                                    </p:nvPicPr>
                                    <p:blipFill>
                                      <a:blip r:embed="rId9">
                                        <a:extLst>
                                          <a:ext uri="{28A0092B-C50C-407E-A947-70E740481C1C}">
                                            <a14:useLocalDpi xmlns:a14="http://schemas.microsoft.com/office/drawing/2010/main" val="0"/>
                                          </a:ext>
                                        </a:extLst>
                                      </a:blip>
                                      <a:stretch>
                                        <a:fillRect/>
                                      </a:stretch>
                                    </p:blipFill>
                                    <p:spPr>
                                      <a:xfrm>
                                        <a:off x="1810218" y="3938779"/>
                                        <a:ext cx="2340000" cy="540000"/>
                                      </a:xfrm>
                                      <a:prstGeom prst="rect">
                                        <a:avLst/>
                                      </a:prstGeom>
                                      <a:ln w="9525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</p:pic>
                                  <p:sp>
                                    <p:nvSpPr>
                                      <p:cNvPr id="130" name="Szövegdoboz 129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96CAD82D-E961-45F1-118A-D3BB3FF74D1C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3708860" y="3714053"/>
                                        <a:ext cx="470000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DMSO</a:t>
                                        </a:r>
                                      </a:p>
                                    </p:txBody>
                                  </p:sp>
                                  <p:sp>
                                    <p:nvSpPr>
                                      <p:cNvPr id="131" name="Szövegdoboz 130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C1B862EC-357A-1717-4AE7-6A80F94D7BDF}"/>
                                          </a:ext>
                                        </a:extLst>
                                      </p:cNvPr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3316746" y="3720388"/>
                                        <a:ext cx="457176" cy="215444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none" rtlCol="0">
                                        <a:spAutoFit/>
                                      </a:bodyPr>
                                      <a:lstStyle/>
                                      <a:p>
                                        <a:r>
                                          <a:rPr lang="hu-HU" sz="800" dirty="0"/>
                                          <a:t>UDCA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133" name="Szövegdoboz 132">
                                      <a:extLst>
                                        <a:ext uri="{FF2B5EF4-FFF2-40B4-BE49-F238E27FC236}">
                                          <a16:creationId xmlns:a16="http://schemas.microsoft.com/office/drawing/2014/main" id="{CF9C068E-56D8-9472-013D-B2697A2831A2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495949" y="3855401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55</a:t>
                                      </a:r>
                                    </a:p>
                                  </p:txBody>
                                </p:sp>
                                <p:sp>
                                  <p:nvSpPr>
                                    <p:cNvPr id="134" name="Szövegdoboz 133">
                                      <a:extLst>
                                        <a:ext uri="{FF2B5EF4-FFF2-40B4-BE49-F238E27FC236}">
                                          <a16:creationId xmlns:a16="http://schemas.microsoft.com/office/drawing/2014/main" id="{DCD6B053-A731-5B71-0675-6B6C3DE18F87}"/>
                                        </a:ext>
                                      </a:extLst>
                                    </p:cNvPr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1500188" y="4290995"/>
                                      <a:ext cx="293670" cy="215444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none" rtlCol="0">
                                      <a:spAutoFit/>
                                    </a:bodyPr>
                                    <a:lstStyle/>
                                    <a:p>
                                      <a:r>
                                        <a:rPr lang="hu-HU" sz="800" dirty="0"/>
                                        <a:t>35</a:t>
                                      </a:r>
                                    </a:p>
                                  </p:txBody>
                                </p:sp>
                              </p:grpSp>
                              <p:pic>
                                <p:nvPicPr>
                                  <p:cNvPr id="137" name="Kép 136">
                                    <a:extLst>
                                      <a:ext uri="{FF2B5EF4-FFF2-40B4-BE49-F238E27FC236}">
                                        <a16:creationId xmlns:a16="http://schemas.microsoft.com/office/drawing/2014/main" id="{7B935022-A40E-94B7-EC2E-29C8E4CDC59D}"/>
                                      </a:ext>
                                    </a:extLst>
                                  </p:cNvPr>
                                  <p:cNvPicPr>
                                    <a:picLocks/>
                                  </p:cNvPicPr>
                                  <p:nvPr/>
                                </p:nvPicPr>
                                <p:blipFill>
                                  <a:blip r:embed="rId10">
                                    <a:extLst>
                                      <a:ext uri="{28A0092B-C50C-407E-A947-70E740481C1C}">
                                        <a14:useLocalDpi xmlns:a14="http://schemas.microsoft.com/office/drawing/2010/main" val="0"/>
                                      </a:ext>
                                    </a:extLst>
                                  </a:blip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5610614" y="2999599"/>
                                    <a:ext cx="2340000" cy="540000"/>
                                  </a:xfrm>
                                  <a:prstGeom prst="rect">
                                    <a:avLst/>
                                  </a:prstGeom>
                                  <a:ln w="9525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</p:pic>
                            </p:grpSp>
                            <p:sp>
                              <p:nvSpPr>
                                <p:cNvPr id="139" name="Szövegdoboz 138">
                                  <a:extLst>
                                    <a:ext uri="{FF2B5EF4-FFF2-40B4-BE49-F238E27FC236}">
                                      <a16:creationId xmlns:a16="http://schemas.microsoft.com/office/drawing/2014/main" id="{A7A8C908-011D-7365-2F8D-96A9F9C07015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7225068" y="2771372"/>
                                  <a:ext cx="470000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DMSO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40" name="Szövegdoboz 139">
                                  <a:extLst>
                                    <a:ext uri="{FF2B5EF4-FFF2-40B4-BE49-F238E27FC236}">
                                      <a16:creationId xmlns:a16="http://schemas.microsoft.com/office/drawing/2014/main" id="{AF2845CE-9BE8-9C74-3599-24D614246D61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6870662" y="2777707"/>
                                  <a:ext cx="457176" cy="21544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hu-HU" sz="800" dirty="0"/>
                                    <a:t>UDCA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142" name="Szövegdoboz 141">
                                <a:extLst>
                                  <a:ext uri="{FF2B5EF4-FFF2-40B4-BE49-F238E27FC236}">
                                    <a16:creationId xmlns:a16="http://schemas.microsoft.com/office/drawing/2014/main" id="{50F76844-AADE-D5A8-B290-139D0072A8D9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958166" y="3082759"/>
                                <a:ext cx="348172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250</a:t>
                                </a:r>
                              </a:p>
                            </p:txBody>
                          </p:sp>
                          <p:sp>
                            <p:nvSpPr>
                              <p:cNvPr id="143" name="Szövegdoboz 142">
                                <a:extLst>
                                  <a:ext uri="{FF2B5EF4-FFF2-40B4-BE49-F238E27FC236}">
                                    <a16:creationId xmlns:a16="http://schemas.microsoft.com/office/drawing/2014/main" id="{8E3DA2B4-8C24-3C82-4462-0C17E19E5AAD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948739" y="3300695"/>
                                <a:ext cx="348172" cy="21544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r>
                                  <a:rPr lang="hu-HU" sz="800" dirty="0"/>
                                  <a:t>130</a:t>
                                </a:r>
                              </a:p>
                            </p:txBody>
                          </p:sp>
                        </p:grpSp>
                        <p:pic>
                          <p:nvPicPr>
                            <p:cNvPr id="146" name="Kép 145" descr="A képen fehér, fekete, fekete-fehér, monokróm látható&#10;&#10;Automatikusan generált leírás">
                              <a:extLst>
                                <a:ext uri="{FF2B5EF4-FFF2-40B4-BE49-F238E27FC236}">
                                  <a16:creationId xmlns:a16="http://schemas.microsoft.com/office/drawing/2014/main" id="{E8E6976D-6BC9-1EBD-42C0-8A634153B2FE}"/>
                                </a:ext>
                              </a:extLst>
                            </p:cNvPr>
                            <p:cNvPicPr>
                              <a:picLocks/>
                            </p:cNvPicPr>
                            <p:nvPr/>
                          </p:nvPicPr>
                          <p:blipFill>
                            <a:blip r:embed="rId11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603945" y="3938720"/>
                              <a:ext cx="2340000" cy="540000"/>
                            </a:xfrm>
                            <a:prstGeom prst="rect">
                              <a:avLst/>
                            </a:prstGeom>
                            <a:ln w="9525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grpSp>
                      <p:sp>
                        <p:nvSpPr>
                          <p:cNvPr id="148" name="Szövegdoboz 147">
                            <a:extLst>
                              <a:ext uri="{FF2B5EF4-FFF2-40B4-BE49-F238E27FC236}">
                                <a16:creationId xmlns:a16="http://schemas.microsoft.com/office/drawing/2014/main" id="{87895C2D-1CB8-CB30-B367-F7C20FE47A5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7264344" y="3706199"/>
                            <a:ext cx="470000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DMSO</a:t>
                            </a:r>
                          </a:p>
                        </p:txBody>
                      </p:sp>
                      <p:sp>
                        <p:nvSpPr>
                          <p:cNvPr id="149" name="Szövegdoboz 148">
                            <a:extLst>
                              <a:ext uri="{FF2B5EF4-FFF2-40B4-BE49-F238E27FC236}">
                                <a16:creationId xmlns:a16="http://schemas.microsoft.com/office/drawing/2014/main" id="{4284E4C4-1867-D291-A098-660CA4585A0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909938" y="3712534"/>
                            <a:ext cx="457176" cy="21544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hu-HU" sz="800" dirty="0"/>
                              <a:t>UDCA</a:t>
                            </a:r>
                          </a:p>
                        </p:txBody>
                      </p:sp>
                    </p:grpSp>
                    <p:sp>
                      <p:nvSpPr>
                        <p:cNvPr id="151" name="Szövegdoboz 150">
                          <a:extLst>
                            <a:ext uri="{FF2B5EF4-FFF2-40B4-BE49-F238E27FC236}">
                              <a16:creationId xmlns:a16="http://schemas.microsoft.com/office/drawing/2014/main" id="{C27FD1C4-5C6B-E31B-87E5-F478B366704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296524" y="3904104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55</a:t>
                          </a:r>
                        </a:p>
                      </p:txBody>
                    </p:sp>
                    <p:sp>
                      <p:nvSpPr>
                        <p:cNvPr id="152" name="Szövegdoboz 151">
                          <a:extLst>
                            <a:ext uri="{FF2B5EF4-FFF2-40B4-BE49-F238E27FC236}">
                              <a16:creationId xmlns:a16="http://schemas.microsoft.com/office/drawing/2014/main" id="{E915703C-3FA9-6CA3-2DDE-1C7D331946B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291336" y="4311417"/>
                          <a:ext cx="293670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hu-HU" sz="800" dirty="0"/>
                            <a:t>35</a:t>
                          </a:r>
                        </a:p>
                      </p:txBody>
                    </p:sp>
                  </p:grpSp>
                  <p:pic>
                    <p:nvPicPr>
                      <p:cNvPr id="158" name="Kép 157" descr="A képen fekete, fehér, fekete-fehér, monokróm látható&#10;&#10;Automatikusan generált leírás">
                        <a:extLst>
                          <a:ext uri="{FF2B5EF4-FFF2-40B4-BE49-F238E27FC236}">
                            <a16:creationId xmlns:a16="http://schemas.microsoft.com/office/drawing/2014/main" id="{DF5AB69E-0F91-2AB3-6ED8-A674153B9506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9269248" y="2993946"/>
                        <a:ext cx="2340000" cy="540000"/>
                      </a:xfrm>
                      <a:prstGeom prst="rect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</p:pic>
                </p:grpSp>
                <p:sp>
                  <p:nvSpPr>
                    <p:cNvPr id="160" name="Szövegdoboz 159">
                      <a:extLst>
                        <a:ext uri="{FF2B5EF4-FFF2-40B4-BE49-F238E27FC236}">
                          <a16:creationId xmlns:a16="http://schemas.microsoft.com/office/drawing/2014/main" id="{992AA662-42FC-019F-ABAD-6830E39C97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470217" y="2763517"/>
                      <a:ext cx="47000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DMSO</a:t>
                      </a:r>
                    </a:p>
                  </p:txBody>
                </p:sp>
                <p:sp>
                  <p:nvSpPr>
                    <p:cNvPr id="161" name="Szövegdoboz 160">
                      <a:extLst>
                        <a:ext uri="{FF2B5EF4-FFF2-40B4-BE49-F238E27FC236}">
                          <a16:creationId xmlns:a16="http://schemas.microsoft.com/office/drawing/2014/main" id="{E644835C-C233-2688-C5FB-B7EA222888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13397" y="2760425"/>
                      <a:ext cx="45717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hu-HU" sz="800" dirty="0"/>
                        <a:t>UDCA</a:t>
                      </a:r>
                    </a:p>
                  </p:txBody>
                </p:sp>
              </p:grpSp>
              <p:sp>
                <p:nvSpPr>
                  <p:cNvPr id="163" name="Szövegdoboz 162">
                    <a:extLst>
                      <a:ext uri="{FF2B5EF4-FFF2-40B4-BE49-F238E27FC236}">
                        <a16:creationId xmlns:a16="http://schemas.microsoft.com/office/drawing/2014/main" id="{166FE6AB-A5F2-9802-D8C5-E0AD49BF5480}"/>
                      </a:ext>
                    </a:extLst>
                  </p:cNvPr>
                  <p:cNvSpPr txBox="1"/>
                  <p:nvPr/>
                </p:nvSpPr>
                <p:spPr>
                  <a:xfrm>
                    <a:off x="8911849" y="3008914"/>
                    <a:ext cx="3481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250</a:t>
                    </a:r>
                  </a:p>
                </p:txBody>
              </p:sp>
              <p:sp>
                <p:nvSpPr>
                  <p:cNvPr id="164" name="Szövegdoboz 163">
                    <a:extLst>
                      <a:ext uri="{FF2B5EF4-FFF2-40B4-BE49-F238E27FC236}">
                        <a16:creationId xmlns:a16="http://schemas.microsoft.com/office/drawing/2014/main" id="{B5C72B50-357F-7A36-2199-785CE68545A0}"/>
                      </a:ext>
                    </a:extLst>
                  </p:cNvPr>
                  <p:cNvSpPr txBox="1"/>
                  <p:nvPr/>
                </p:nvSpPr>
                <p:spPr>
                  <a:xfrm>
                    <a:off x="8911849" y="3283412"/>
                    <a:ext cx="3481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800" dirty="0"/>
                      <a:t>130</a:t>
                    </a:r>
                  </a:p>
                </p:txBody>
              </p:sp>
            </p:grpSp>
            <p:pic>
              <p:nvPicPr>
                <p:cNvPr id="167" name="Kép 166" descr="A képen fekete, fehér, fekete-fehér, klarinét látható&#10;&#10;Automatikusan generált leírás">
                  <a:extLst>
                    <a:ext uri="{FF2B5EF4-FFF2-40B4-BE49-F238E27FC236}">
                      <a16:creationId xmlns:a16="http://schemas.microsoft.com/office/drawing/2014/main" id="{641D089C-2BF3-3D1A-9062-9CE3A7631D4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269248" y="3938720"/>
                  <a:ext cx="2340000" cy="54000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</p:grpSp>
          <p:sp>
            <p:nvSpPr>
              <p:cNvPr id="169" name="Szövegdoboz 168">
                <a:extLst>
                  <a:ext uri="{FF2B5EF4-FFF2-40B4-BE49-F238E27FC236}">
                    <a16:creationId xmlns:a16="http://schemas.microsoft.com/office/drawing/2014/main" id="{1B5368F7-AFB8-E2A7-E75E-2DAE876C0623}"/>
                  </a:ext>
                </a:extLst>
              </p:cNvPr>
              <p:cNvSpPr txBox="1"/>
              <p:nvPr/>
            </p:nvSpPr>
            <p:spPr>
              <a:xfrm>
                <a:off x="9443505" y="3717195"/>
                <a:ext cx="4700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DMSO</a:t>
                </a:r>
              </a:p>
            </p:txBody>
          </p:sp>
          <p:sp>
            <p:nvSpPr>
              <p:cNvPr id="170" name="Szövegdoboz 169">
                <a:extLst>
                  <a:ext uri="{FF2B5EF4-FFF2-40B4-BE49-F238E27FC236}">
                    <a16:creationId xmlns:a16="http://schemas.microsoft.com/office/drawing/2014/main" id="{32774A40-FBAD-7699-659E-A9F4C272116D}"/>
                  </a:ext>
                </a:extLst>
              </p:cNvPr>
              <p:cNvSpPr txBox="1"/>
              <p:nvPr/>
            </p:nvSpPr>
            <p:spPr>
              <a:xfrm>
                <a:off x="9786685" y="3714103"/>
                <a:ext cx="4571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/>
                  <a:t>UDCA</a:t>
                </a:r>
              </a:p>
            </p:txBody>
          </p:sp>
        </p:grpSp>
        <p:sp>
          <p:nvSpPr>
            <p:cNvPr id="172" name="Szövegdoboz 171">
              <a:extLst>
                <a:ext uri="{FF2B5EF4-FFF2-40B4-BE49-F238E27FC236}">
                  <a16:creationId xmlns:a16="http://schemas.microsoft.com/office/drawing/2014/main" id="{B04D0DE7-31E6-9B89-C1BF-148ECD640B7C}"/>
                </a:ext>
              </a:extLst>
            </p:cNvPr>
            <p:cNvSpPr txBox="1"/>
            <p:nvPr/>
          </p:nvSpPr>
          <p:spPr>
            <a:xfrm>
              <a:off x="8965124" y="3924526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5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46016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26</TotalTime>
  <Words>143</Words>
  <Application>Microsoft Office PowerPoint</Application>
  <PresentationFormat>Szélesvásznú</PresentationFormat>
  <Paragraphs>119</Paragraphs>
  <Slides>2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-téma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Patrik</dc:creator>
  <cp:lastModifiedBy>Edit</cp:lastModifiedBy>
  <cp:revision>182</cp:revision>
  <dcterms:created xsi:type="dcterms:W3CDTF">2024-03-11T09:39:17Z</dcterms:created>
  <dcterms:modified xsi:type="dcterms:W3CDTF">2024-11-21T11:02:51Z</dcterms:modified>
</cp:coreProperties>
</file>